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drawings/drawing3.xml" ContentType="application/vnd.openxmlformats-officedocument.drawingml.chartshapes+xml"/>
  <Override PartName="/ppt/drawings/drawing4.xml" ContentType="application/vnd.openxmlformats-officedocument.drawingml.chartshap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drawings/drawing1.xml" ContentType="application/vnd.openxmlformats-officedocument.drawingml.chartshapes+xml"/>
  <Override PartName="/ppt/drawings/drawing2.xml" ContentType="application/vnd.openxmlformats-officedocument.drawingml.chartshape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drawings/drawing5.xml" ContentType="application/vnd.openxmlformats-officedocument.drawingml.chartshapes+xml"/>
  <Override PartName="/ppt/drawings/drawing6.xml" ContentType="application/vnd.openxmlformats-officedocument.drawingml.chartshapes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70" r:id="rId2"/>
    <p:sldId id="271" r:id="rId3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20"/>
    <p:restoredTop sz="94659" autoAdjust="0"/>
  </p:normalViewPr>
  <p:slideViewPr>
    <p:cSldViewPr>
      <p:cViewPr>
        <p:scale>
          <a:sx n="59" d="100"/>
          <a:sy n="59" d="100"/>
        </p:scale>
        <p:origin x="-1500" y="-18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USER\Desktop\Ajay'sLAB\NERICAmanuscript\NERICAGenomeSizePrediction20160831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C:\Users\USER\Desktop\Ajay'sLAB\NERICAmanuscript\NERICAGenomeSizePrediction20160831.xlsx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file:///C:\Users\USER\Desktop\Ajay'sLAB\NERICAmanuscript\NERICAGenomeSizePrediction20160831.xlsx" TargetMode="Externa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.xml"/><Relationship Id="rId1" Type="http://schemas.openxmlformats.org/officeDocument/2006/relationships/oleObject" Target="file:///C:\Users\USER\Desktop\Ajay'sLAB\NERICAmanuscript\NERICAGenomeSizePrediction20160831.xlsx" TargetMode="Externa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5.xml"/><Relationship Id="rId1" Type="http://schemas.openxmlformats.org/officeDocument/2006/relationships/oleObject" Target="file:///C:\Users\USER\Desktop\Ajay'sLAB\NERICAmanuscript\NERICAGenomeSizePrediction20160831.xlsx" TargetMode="Externa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6.xml"/><Relationship Id="rId1" Type="http://schemas.openxmlformats.org/officeDocument/2006/relationships/oleObject" Target="file:///C:\Users\USER\Desktop\Ajay'sLAB\NERICAmanuscript\NERICAGenomeSizePrediction2016083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title>
      <c:layout>
        <c:manualLayout>
          <c:xMode val="edge"/>
          <c:yMode val="edge"/>
          <c:x val="0.71836468983401058"/>
          <c:y val="4.9549567124057302E-2"/>
        </c:manualLayout>
      </c:layout>
    </c:title>
    <c:plotArea>
      <c:layout>
        <c:manualLayout>
          <c:layoutTarget val="inner"/>
          <c:xMode val="edge"/>
          <c:yMode val="edge"/>
          <c:x val="0.13179047546634312"/>
          <c:y val="1.5851032770922969E-2"/>
          <c:w val="0.85142025293998702"/>
          <c:h val="0.7752840232971635"/>
        </c:manualLayout>
      </c:layout>
      <c:lineChart>
        <c:grouping val="standard"/>
        <c:ser>
          <c:idx val="0"/>
          <c:order val="0"/>
          <c:tx>
            <c:strRef>
              <c:f>'C:\Users\USER\Desktop\Ajay''sLAB\NERICAmanuscript\[NERICAstats.xlsx]Summary'!$J$2</c:f>
              <c:strCache>
                <c:ptCount val="1"/>
                <c:pt idx="0">
                  <c:v>WAB 56-104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none"/>
          </c:marker>
          <c:cat>
            <c:numRef>
              <c:f>'C:\Users\USER\Desktop\Ajay''sLAB\NERICAmanuscript\[NERICAstats.xlsx]Summary'!$B$3:$B$102</c:f>
              <c:numCache>
                <c:formatCode>General</c:formatCode>
                <c:ptCount val="100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</c:numCache>
            </c:numRef>
          </c:cat>
          <c:val>
            <c:numRef>
              <c:f>'C:\Users\USER\Desktop\Ajay''sLAB\NERICAmanuscript\[NERICAstats.xlsx]Summary'!$J$3:$J$102</c:f>
              <c:numCache>
                <c:formatCode>General</c:formatCode>
                <c:ptCount val="100"/>
                <c:pt idx="0">
                  <c:v>0</c:v>
                </c:pt>
                <c:pt idx="1">
                  <c:v>0.27400413680725638</c:v>
                </c:pt>
                <c:pt idx="2">
                  <c:v>6.7935628653600533E-2</c:v>
                </c:pt>
                <c:pt idx="3">
                  <c:v>2.7185780331321751E-2</c:v>
                </c:pt>
                <c:pt idx="4">
                  <c:v>1.39275742624207E-2</c:v>
                </c:pt>
                <c:pt idx="5">
                  <c:v>8.470279186515571E-3</c:v>
                </c:pt>
                <c:pt idx="6">
                  <c:v>5.8109087007066898E-3</c:v>
                </c:pt>
                <c:pt idx="7">
                  <c:v>4.3260133085727724E-3</c:v>
                </c:pt>
                <c:pt idx="8">
                  <c:v>3.4423386679872173E-3</c:v>
                </c:pt>
                <c:pt idx="9">
                  <c:v>2.8947401690204142E-3</c:v>
                </c:pt>
                <c:pt idx="10">
                  <c:v>2.5924838713535041E-3</c:v>
                </c:pt>
                <c:pt idx="11">
                  <c:v>2.4327524288831667E-3</c:v>
                </c:pt>
                <c:pt idx="12">
                  <c:v>2.403719165409662E-3</c:v>
                </c:pt>
                <c:pt idx="13">
                  <c:v>2.494082274106261E-3</c:v>
                </c:pt>
                <c:pt idx="14">
                  <c:v>2.6688694804411252E-3</c:v>
                </c:pt>
                <c:pt idx="15">
                  <c:v>2.9749025555534086E-3</c:v>
                </c:pt>
                <c:pt idx="16">
                  <c:v>3.3859836716045441E-3</c:v>
                </c:pt>
                <c:pt idx="17">
                  <c:v>3.9167806455311519E-3</c:v>
                </c:pt>
                <c:pt idx="18">
                  <c:v>4.6049585599530155E-3</c:v>
                </c:pt>
                <c:pt idx="19">
                  <c:v>5.4828254068235065E-3</c:v>
                </c:pt>
                <c:pt idx="20">
                  <c:v>6.5533820697321193E-3</c:v>
                </c:pt>
                <c:pt idx="21">
                  <c:v>7.8511501201620985E-3</c:v>
                </c:pt>
                <c:pt idx="22">
                  <c:v>9.3912651934043214E-3</c:v>
                </c:pt>
                <c:pt idx="23">
                  <c:v>1.1236249500975024E-2</c:v>
                </c:pt>
                <c:pt idx="24">
                  <c:v>1.3375189182975524E-2</c:v>
                </c:pt>
                <c:pt idx="25">
                  <c:v>1.5877058921149607E-2</c:v>
                </c:pt>
                <c:pt idx="26">
                  <c:v>1.8719015487565049E-2</c:v>
                </c:pt>
                <c:pt idx="27">
                  <c:v>2.1901635097511692E-2</c:v>
                </c:pt>
                <c:pt idx="28">
                  <c:v>2.5390327718283829E-2</c:v>
                </c:pt>
                <c:pt idx="29">
                  <c:v>2.9106117624539688E-2</c:v>
                </c:pt>
                <c:pt idx="30">
                  <c:v>3.3014477539694081E-2</c:v>
                </c:pt>
                <c:pt idx="31">
                  <c:v>3.6950917966307992E-2</c:v>
                </c:pt>
                <c:pt idx="32">
                  <c:v>4.0794097092469533E-2</c:v>
                </c:pt>
                <c:pt idx="33">
                  <c:v>4.4502858313207633E-2</c:v>
                </c:pt>
                <c:pt idx="34">
                  <c:v>4.7812832912449019E-2</c:v>
                </c:pt>
                <c:pt idx="35">
                  <c:v>5.0587372289933812E-2</c:v>
                </c:pt>
                <c:pt idx="36">
                  <c:v>5.2813794004181056E-2</c:v>
                </c:pt>
                <c:pt idx="37">
                  <c:v>5.4298638050397953E-2</c:v>
                </c:pt>
                <c:pt idx="38">
                  <c:v>5.5074315112371874E-2</c:v>
                </c:pt>
                <c:pt idx="39">
                  <c:v>5.5012814114092555E-2</c:v>
                </c:pt>
                <c:pt idx="40">
                  <c:v>5.4164596681698693E-2</c:v>
                </c:pt>
                <c:pt idx="41">
                  <c:v>5.256909077429172E-2</c:v>
                </c:pt>
                <c:pt idx="42">
                  <c:v>5.0309145881390495E-2</c:v>
                </c:pt>
                <c:pt idx="43">
                  <c:v>4.7474001206621479E-2</c:v>
                </c:pt>
                <c:pt idx="44">
                  <c:v>4.4207157177602222E-2</c:v>
                </c:pt>
                <c:pt idx="45">
                  <c:v>4.0592147896078123E-2</c:v>
                </c:pt>
                <c:pt idx="46">
                  <c:v>3.6821434974011802E-2</c:v>
                </c:pt>
                <c:pt idx="47">
                  <c:v>3.2947665091563251E-2</c:v>
                </c:pt>
                <c:pt idx="48">
                  <c:v>2.9127990985152192E-2</c:v>
                </c:pt>
                <c:pt idx="49">
                  <c:v>2.5448474116657151E-2</c:v>
                </c:pt>
                <c:pt idx="50">
                  <c:v>2.2010756581193815E-2</c:v>
                </c:pt>
                <c:pt idx="51">
                  <c:v>1.8817308687876538E-2</c:v>
                </c:pt>
                <c:pt idx="52">
                  <c:v>1.5944590212117676E-2</c:v>
                </c:pt>
                <c:pt idx="53">
                  <c:v>1.339509428343909E-2</c:v>
                </c:pt>
                <c:pt idx="54">
                  <c:v>1.1203667664131422E-2</c:v>
                </c:pt>
                <c:pt idx="55">
                  <c:v>9.3302434236828026E-3</c:v>
                </c:pt>
                <c:pt idx="56">
                  <c:v>7.7421826742308424E-3</c:v>
                </c:pt>
                <c:pt idx="57">
                  <c:v>6.4351552434476419E-3</c:v>
                </c:pt>
                <c:pt idx="58">
                  <c:v>5.3867172605325114E-3</c:v>
                </c:pt>
                <c:pt idx="59">
                  <c:v>4.5494593288525481E-3</c:v>
                </c:pt>
                <c:pt idx="60">
                  <c:v>3.8992146368388779E-3</c:v>
                </c:pt>
                <c:pt idx="61">
                  <c:v>3.4186739053839203E-3</c:v>
                </c:pt>
                <c:pt idx="62">
                  <c:v>3.0661214295321969E-3</c:v>
                </c:pt>
                <c:pt idx="63">
                  <c:v>2.8236260740710424E-3</c:v>
                </c:pt>
                <c:pt idx="64">
                  <c:v>2.6731882425652218E-3</c:v>
                </c:pt>
                <c:pt idx="65">
                  <c:v>2.5998605680859262E-3</c:v>
                </c:pt>
                <c:pt idx="66">
                  <c:v>2.5799668778261208E-3</c:v>
                </c:pt>
                <c:pt idx="67">
                  <c:v>2.6004938343947375E-3</c:v>
                </c:pt>
                <c:pt idx="68">
                  <c:v>2.6634154030426862E-3</c:v>
                </c:pt>
                <c:pt idx="69">
                  <c:v>2.7377186499436654E-3</c:v>
                </c:pt>
                <c:pt idx="70">
                  <c:v>2.8328055829979193E-3</c:v>
                </c:pt>
                <c:pt idx="71">
                  <c:v>2.9350124831999265E-3</c:v>
                </c:pt>
                <c:pt idx="72">
                  <c:v>3.0338647834957898E-3</c:v>
                </c:pt>
                <c:pt idx="73">
                  <c:v>3.1409552509081284E-3</c:v>
                </c:pt>
                <c:pt idx="74">
                  <c:v>3.2269653668693683E-3</c:v>
                </c:pt>
                <c:pt idx="75">
                  <c:v>3.3144873348291172E-3</c:v>
                </c:pt>
                <c:pt idx="76">
                  <c:v>3.3854302767220711E-3</c:v>
                </c:pt>
                <c:pt idx="77">
                  <c:v>3.44079258537741E-3</c:v>
                </c:pt>
                <c:pt idx="78">
                  <c:v>3.4798839434675055E-3</c:v>
                </c:pt>
                <c:pt idx="79">
                  <c:v>3.5030580673090111E-3</c:v>
                </c:pt>
                <c:pt idx="80">
                  <c:v>3.5140803241435212E-3</c:v>
                </c:pt>
                <c:pt idx="81">
                  <c:v>3.4901417166499395E-3</c:v>
                </c:pt>
                <c:pt idx="82">
                  <c:v>3.4544220737716242E-3</c:v>
                </c:pt>
                <c:pt idx="83">
                  <c:v>3.3964354182509319E-3</c:v>
                </c:pt>
                <c:pt idx="84">
                  <c:v>3.3200726295708285E-3</c:v>
                </c:pt>
                <c:pt idx="85">
                  <c:v>3.2272620321671915E-3</c:v>
                </c:pt>
                <c:pt idx="86">
                  <c:v>3.1308172848652041E-3</c:v>
                </c:pt>
                <c:pt idx="87">
                  <c:v>3.0178562676171001E-3</c:v>
                </c:pt>
                <c:pt idx="88">
                  <c:v>2.8876030865670208E-3</c:v>
                </c:pt>
                <c:pt idx="89">
                  <c:v>2.7462934180711401E-3</c:v>
                </c:pt>
                <c:pt idx="90">
                  <c:v>2.602091262921491E-3</c:v>
                </c:pt>
                <c:pt idx="91">
                  <c:v>2.4588190393784546E-3</c:v>
                </c:pt>
                <c:pt idx="92">
                  <c:v>2.3136184913995837E-3</c:v>
                </c:pt>
                <c:pt idx="93">
                  <c:v>2.1684179434207237E-3</c:v>
                </c:pt>
                <c:pt idx="94">
                  <c:v>2.0247920035610699E-3</c:v>
                </c:pt>
                <c:pt idx="95">
                  <c:v>1.8850911737956907E-3</c:v>
                </c:pt>
                <c:pt idx="96">
                  <c:v>1.7539993427690701E-3</c:v>
                </c:pt>
                <c:pt idx="97">
                  <c:v>1.6269239034668345E-3</c:v>
                </c:pt>
                <c:pt idx="98">
                  <c:v>1.511806357707618E-3</c:v>
                </c:pt>
                <c:pt idx="99">
                  <c:v>1.4062391524975681E-3</c:v>
                </c:pt>
              </c:numCache>
            </c:numRef>
          </c:val>
        </c:ser>
        <c:marker val="1"/>
        <c:axId val="71017216"/>
        <c:axId val="71018752"/>
      </c:lineChart>
      <c:catAx>
        <c:axId val="71017216"/>
        <c:scaling>
          <c:orientation val="minMax"/>
        </c:scaling>
        <c:axPos val="b"/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fil-PH" sz="800"/>
            </a:pPr>
            <a:endParaRPr lang="ja-JP"/>
          </a:p>
        </c:txPr>
        <c:crossAx val="71018752"/>
        <c:crosses val="autoZero"/>
        <c:auto val="1"/>
        <c:lblAlgn val="ctr"/>
        <c:lblOffset val="100"/>
      </c:catAx>
      <c:valAx>
        <c:axId val="71018752"/>
        <c:scaling>
          <c:orientation val="minMax"/>
          <c:max val="6.0000000000000143E-2"/>
        </c:scaling>
        <c:axPos val="l"/>
        <c:majorGridlines/>
        <c:numFmt formatCode="General" sourceLinked="0"/>
        <c:tickLblPos val="nextTo"/>
        <c:spPr>
          <a:noFill/>
          <a:ln>
            <a:solidFill>
              <a:schemeClr val="tx1"/>
            </a:solidFill>
          </a:ln>
        </c:spPr>
        <c:txPr>
          <a:bodyPr/>
          <a:lstStyle/>
          <a:p>
            <a:pPr>
              <a:defRPr lang="fil-PH"/>
            </a:pPr>
            <a:endParaRPr lang="ja-JP"/>
          </a:p>
        </c:txPr>
        <c:crossAx val="71017216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</c:chart>
  <c:spPr>
    <a:ln>
      <a:noFill/>
    </a:ln>
  </c:spPr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ja-JP"/>
    </a:p>
  </c:txPr>
  <c:externalData r:id="rId1"/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title>
      <c:layout>
        <c:manualLayout>
          <c:xMode val="edge"/>
          <c:yMode val="edge"/>
          <c:x val="0.8430302129901025"/>
          <c:y val="3.1531542715309342E-2"/>
        </c:manualLayout>
      </c:layout>
    </c:title>
    <c:plotArea>
      <c:layout>
        <c:manualLayout>
          <c:layoutTarget val="inner"/>
          <c:xMode val="edge"/>
          <c:yMode val="edge"/>
          <c:x val="0.13179047546634312"/>
          <c:y val="1.5851032770922969E-2"/>
          <c:w val="0.85142025293998702"/>
          <c:h val="0.77528402329716373"/>
        </c:manualLayout>
      </c:layout>
      <c:lineChart>
        <c:grouping val="standard"/>
        <c:ser>
          <c:idx val="5"/>
          <c:order val="0"/>
          <c:tx>
            <c:strRef>
              <c:f>'C:\Users\USER\Desktop\Ajay''sLAB\NERICAmanuscript\[NERICAstats.xlsx]Summary'!$O$2</c:f>
              <c:strCache>
                <c:ptCount val="1"/>
                <c:pt idx="0">
                  <c:v>CG 14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none"/>
          </c:marker>
          <c:cat>
            <c:numRef>
              <c:f>'C:\Users\USER\Desktop\Ajay''sLAB\NERICAmanuscript\[NERICAstats.xlsx]Summary'!$B$3:$B$102</c:f>
              <c:numCache>
                <c:formatCode>General</c:formatCode>
                <c:ptCount val="100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</c:numCache>
            </c:numRef>
          </c:cat>
          <c:val>
            <c:numRef>
              <c:f>'C:\Users\USER\Desktop\Ajay''sLAB\NERICAmanuscript\[NERICAstats.xlsx]Summary'!$O$3:$O$102</c:f>
              <c:numCache>
                <c:formatCode>General</c:formatCode>
                <c:ptCount val="100"/>
                <c:pt idx="0">
                  <c:v>0</c:v>
                </c:pt>
                <c:pt idx="1">
                  <c:v>0.30561126067268501</c:v>
                </c:pt>
                <c:pt idx="2">
                  <c:v>9.8176445908814719E-2</c:v>
                </c:pt>
                <c:pt idx="3">
                  <c:v>5.3560261441027802E-2</c:v>
                </c:pt>
                <c:pt idx="4">
                  <c:v>3.3382885649397523E-2</c:v>
                </c:pt>
                <c:pt idx="5">
                  <c:v>2.0908131464913212E-2</c:v>
                </c:pt>
                <c:pt idx="6">
                  <c:v>1.2751772822999618E-2</c:v>
                </c:pt>
                <c:pt idx="7">
                  <c:v>7.6898965693554195E-3</c:v>
                </c:pt>
                <c:pt idx="8">
                  <c:v>4.7235249707971065E-3</c:v>
                </c:pt>
                <c:pt idx="9">
                  <c:v>3.064152872041349E-3</c:v>
                </c:pt>
                <c:pt idx="10">
                  <c:v>2.1541202094981183E-3</c:v>
                </c:pt>
                <c:pt idx="11">
                  <c:v>1.7016681318381601E-3</c:v>
                </c:pt>
                <c:pt idx="12">
                  <c:v>1.470641900816825E-3</c:v>
                </c:pt>
                <c:pt idx="13">
                  <c:v>1.3876234825638389E-3</c:v>
                </c:pt>
                <c:pt idx="14">
                  <c:v>1.3932954077710861E-3</c:v>
                </c:pt>
                <c:pt idx="15">
                  <c:v>1.4780006860158441E-3</c:v>
                </c:pt>
                <c:pt idx="16">
                  <c:v>1.6286123766238629E-3</c:v>
                </c:pt>
                <c:pt idx="17">
                  <c:v>1.8563497967216359E-3</c:v>
                </c:pt>
                <c:pt idx="18">
                  <c:v>2.1182489619548722E-3</c:v>
                </c:pt>
                <c:pt idx="19">
                  <c:v>2.4935413465010741E-3</c:v>
                </c:pt>
                <c:pt idx="20">
                  <c:v>2.9332966893907018E-3</c:v>
                </c:pt>
                <c:pt idx="21">
                  <c:v>3.5044572935188992E-3</c:v>
                </c:pt>
                <c:pt idx="22">
                  <c:v>4.1906979769518234E-3</c:v>
                </c:pt>
                <c:pt idx="23">
                  <c:v>5.0355997298797044E-3</c:v>
                </c:pt>
                <c:pt idx="24">
                  <c:v>6.0782716653333393E-3</c:v>
                </c:pt>
                <c:pt idx="25">
                  <c:v>7.3256253807957713E-3</c:v>
                </c:pt>
                <c:pt idx="26">
                  <c:v>8.8331687590837028E-3</c:v>
                </c:pt>
                <c:pt idx="27">
                  <c:v>1.0587418241470881E-2</c:v>
                </c:pt>
                <c:pt idx="28">
                  <c:v>1.264330432916605E-2</c:v>
                </c:pt>
                <c:pt idx="29">
                  <c:v>1.5014803053443279E-2</c:v>
                </c:pt>
                <c:pt idx="30">
                  <c:v>1.7683608020969084E-2</c:v>
                </c:pt>
                <c:pt idx="31">
                  <c:v>2.066887471567689E-2</c:v>
                </c:pt>
                <c:pt idx="32">
                  <c:v>2.3869844386380071E-2</c:v>
                </c:pt>
                <c:pt idx="33">
                  <c:v>2.7290734183058059E-2</c:v>
                </c:pt>
                <c:pt idx="34">
                  <c:v>3.0854961794205032E-2</c:v>
                </c:pt>
                <c:pt idx="35">
                  <c:v>3.4422489537483544E-2</c:v>
                </c:pt>
                <c:pt idx="36">
                  <c:v>3.7906659226269152E-2</c:v>
                </c:pt>
                <c:pt idx="37">
                  <c:v>4.1241190848334566E-2</c:v>
                </c:pt>
                <c:pt idx="38">
                  <c:v>4.4246620614487732E-2</c:v>
                </c:pt>
                <c:pt idx="39">
                  <c:v>4.6904619488978956E-2</c:v>
                </c:pt>
                <c:pt idx="40">
                  <c:v>4.9087455942565431E-2</c:v>
                </c:pt>
                <c:pt idx="41">
                  <c:v>5.0652301615137584E-2</c:v>
                </c:pt>
                <c:pt idx="42">
                  <c:v>5.1577985847738872E-2</c:v>
                </c:pt>
                <c:pt idx="43">
                  <c:v>5.1864474676744723E-2</c:v>
                </c:pt>
                <c:pt idx="44">
                  <c:v>5.1521102438150133E-2</c:v>
                </c:pt>
                <c:pt idx="45">
                  <c:v>5.0435358966866378E-2</c:v>
                </c:pt>
                <c:pt idx="46">
                  <c:v>4.8878313606605016E-2</c:v>
                </c:pt>
                <c:pt idx="47">
                  <c:v>4.6738327925293172E-2</c:v>
                </c:pt>
                <c:pt idx="48">
                  <c:v>4.4167994824938529E-2</c:v>
                </c:pt>
                <c:pt idx="49">
                  <c:v>4.1235915165407276E-2</c:v>
                </c:pt>
                <c:pt idx="50">
                  <c:v>3.8113786387205653E-2</c:v>
                </c:pt>
                <c:pt idx="51">
                  <c:v>3.4809657869220266E-2</c:v>
                </c:pt>
                <c:pt idx="52">
                  <c:v>3.1422556217813695E-2</c:v>
                </c:pt>
                <c:pt idx="53">
                  <c:v>2.8079805398741341E-2</c:v>
                </c:pt>
                <c:pt idx="54">
                  <c:v>2.4847215594098426E-2</c:v>
                </c:pt>
                <c:pt idx="55">
                  <c:v>2.1756327689368631E-2</c:v>
                </c:pt>
                <c:pt idx="56">
                  <c:v>1.889390176204846E-2</c:v>
                </c:pt>
                <c:pt idx="57">
                  <c:v>1.6238591674456862E-2</c:v>
                </c:pt>
                <c:pt idx="58">
                  <c:v>1.3860668164640461E-2</c:v>
                </c:pt>
                <c:pt idx="59">
                  <c:v>1.1727701632287599E-2</c:v>
                </c:pt>
                <c:pt idx="60">
                  <c:v>9.8881468476316996E-3</c:v>
                </c:pt>
                <c:pt idx="61">
                  <c:v>8.2787409003772707E-3</c:v>
                </c:pt>
                <c:pt idx="62">
                  <c:v>6.9244244117450116E-3</c:v>
                </c:pt>
                <c:pt idx="63">
                  <c:v>5.7685573781184147E-3</c:v>
                </c:pt>
                <c:pt idx="64">
                  <c:v>4.8317727010747675E-3</c:v>
                </c:pt>
                <c:pt idx="65">
                  <c:v>4.0865485239696599E-3</c:v>
                </c:pt>
                <c:pt idx="66">
                  <c:v>3.4799072539741602E-3</c:v>
                </c:pt>
                <c:pt idx="67">
                  <c:v>3.0205492394351219E-3</c:v>
                </c:pt>
                <c:pt idx="68">
                  <c:v>2.6761694133288203E-3</c:v>
                </c:pt>
                <c:pt idx="69">
                  <c:v>2.4258858075020492E-3</c:v>
                </c:pt>
                <c:pt idx="70">
                  <c:v>2.2578507777843543E-3</c:v>
                </c:pt>
                <c:pt idx="71">
                  <c:v>2.150078538242655E-3</c:v>
                </c:pt>
                <c:pt idx="72">
                  <c:v>2.1003727745252452E-3</c:v>
                </c:pt>
                <c:pt idx="73">
                  <c:v>2.1013011135811274E-3</c:v>
                </c:pt>
                <c:pt idx="74">
                  <c:v>2.1331023868489071E-3</c:v>
                </c:pt>
                <c:pt idx="75">
                  <c:v>2.1830232535182802E-3</c:v>
                </c:pt>
                <c:pt idx="76">
                  <c:v>2.2662341323072409E-3</c:v>
                </c:pt>
                <c:pt idx="77">
                  <c:v>2.3527960886637438E-3</c:v>
                </c:pt>
                <c:pt idx="78">
                  <c:v>2.4484885992710442E-3</c:v>
                </c:pt>
                <c:pt idx="79">
                  <c:v>2.5463094969820615E-3</c:v>
                </c:pt>
                <c:pt idx="80">
                  <c:v>2.6594027042830541E-3</c:v>
                </c:pt>
                <c:pt idx="81">
                  <c:v>2.7581066562179673E-3</c:v>
                </c:pt>
                <c:pt idx="82">
                  <c:v>2.8576880017727392E-3</c:v>
                </c:pt>
                <c:pt idx="83">
                  <c:v>2.9395969416418691E-3</c:v>
                </c:pt>
                <c:pt idx="84">
                  <c:v>3.0087072558687023E-3</c:v>
                </c:pt>
                <c:pt idx="85">
                  <c:v>3.0706116212044802E-3</c:v>
                </c:pt>
                <c:pt idx="86">
                  <c:v>3.1266346189850504E-3</c:v>
                </c:pt>
                <c:pt idx="87">
                  <c:v>3.1589227041967645E-3</c:v>
                </c:pt>
                <c:pt idx="88">
                  <c:v>3.1829236651535809E-3</c:v>
                </c:pt>
                <c:pt idx="89">
                  <c:v>3.1770706006183569E-3</c:v>
                </c:pt>
                <c:pt idx="90">
                  <c:v>3.1611529821724718E-3</c:v>
                </c:pt>
                <c:pt idx="91">
                  <c:v>3.1215117723657382E-3</c:v>
                </c:pt>
                <c:pt idx="92">
                  <c:v>3.0721116812642791E-3</c:v>
                </c:pt>
                <c:pt idx="93">
                  <c:v>3.0167566347556237E-3</c:v>
                </c:pt>
                <c:pt idx="94">
                  <c:v>2.9418668438455642E-3</c:v>
                </c:pt>
                <c:pt idx="95">
                  <c:v>2.8551294087650813E-3</c:v>
                </c:pt>
                <c:pt idx="96">
                  <c:v>2.7582255289019474E-3</c:v>
                </c:pt>
                <c:pt idx="97">
                  <c:v>2.6406944080655461E-3</c:v>
                </c:pt>
                <c:pt idx="98">
                  <c:v>2.5339297560357144E-3</c:v>
                </c:pt>
                <c:pt idx="99">
                  <c:v>2.4188666585429836E-3</c:v>
                </c:pt>
              </c:numCache>
            </c:numRef>
          </c:val>
        </c:ser>
        <c:marker val="1"/>
        <c:axId val="74526720"/>
        <c:axId val="74529792"/>
      </c:lineChart>
      <c:catAx>
        <c:axId val="74526720"/>
        <c:scaling>
          <c:orientation val="minMax"/>
        </c:scaling>
        <c:axPos val="b"/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fil-PH" sz="800"/>
            </a:pPr>
            <a:endParaRPr lang="ja-JP"/>
          </a:p>
        </c:txPr>
        <c:crossAx val="74529792"/>
        <c:crosses val="autoZero"/>
        <c:auto val="1"/>
        <c:lblAlgn val="ctr"/>
        <c:lblOffset val="100"/>
      </c:catAx>
      <c:valAx>
        <c:axId val="74529792"/>
        <c:scaling>
          <c:orientation val="minMax"/>
          <c:max val="6.0000000000000032E-2"/>
        </c:scaling>
        <c:axPos val="l"/>
        <c:majorGridlines/>
        <c:numFmt formatCode="General" sourceLinked="0"/>
        <c:tickLblPos val="nextTo"/>
        <c:spPr>
          <a:noFill/>
          <a:ln>
            <a:solidFill>
              <a:schemeClr val="tx1"/>
            </a:solidFill>
          </a:ln>
        </c:spPr>
        <c:txPr>
          <a:bodyPr/>
          <a:lstStyle/>
          <a:p>
            <a:pPr>
              <a:defRPr lang="fil-PH"/>
            </a:pPr>
            <a:endParaRPr lang="ja-JP"/>
          </a:p>
        </c:txPr>
        <c:crossAx val="74526720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</c:chart>
  <c:spPr>
    <a:ln>
      <a:noFill/>
    </a:ln>
  </c:spPr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ja-JP"/>
    </a:p>
  </c:txPr>
  <c:externalData r:id="rId1"/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title>
      <c:layout>
        <c:manualLayout>
          <c:xMode val="edge"/>
          <c:yMode val="edge"/>
          <c:x val="0.77604690428910295"/>
          <c:y val="2.7409381778156758E-2"/>
        </c:manualLayout>
      </c:layout>
    </c:title>
    <c:plotArea>
      <c:layout>
        <c:manualLayout>
          <c:layoutTarget val="inner"/>
          <c:xMode val="edge"/>
          <c:yMode val="edge"/>
          <c:x val="0.13179047546634318"/>
          <c:y val="1.5851032770922969E-2"/>
          <c:w val="0.85142025293998713"/>
          <c:h val="0.77528402329716373"/>
        </c:manualLayout>
      </c:layout>
      <c:lineChart>
        <c:grouping val="standard"/>
        <c:ser>
          <c:idx val="1"/>
          <c:order val="0"/>
          <c:tx>
            <c:strRef>
              <c:f>'C:\Users\USER\Desktop\Ajay''sLAB\NERICAmanuscript\[NERICAstats.xlsx]Summary'!$K$2</c:f>
              <c:strCache>
                <c:ptCount val="1"/>
                <c:pt idx="0">
                  <c:v>NERICA 3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none"/>
          </c:marker>
          <c:cat>
            <c:numRef>
              <c:f>'C:\Users\USER\Desktop\Ajay''sLAB\NERICAmanuscript\[NERICAstats.xlsx]Summary'!$B$3:$B$102</c:f>
              <c:numCache>
                <c:formatCode>General</c:formatCode>
                <c:ptCount val="100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</c:numCache>
            </c:numRef>
          </c:cat>
          <c:val>
            <c:numRef>
              <c:f>'C:\Users\USER\Desktop\Ajay''sLAB\NERICAmanuscript\[NERICAstats.xlsx]Summary'!$K$3:$K$102</c:f>
              <c:numCache>
                <c:formatCode>General</c:formatCode>
                <c:ptCount val="100"/>
                <c:pt idx="0">
                  <c:v>0</c:v>
                </c:pt>
                <c:pt idx="1">
                  <c:v>0.29243564600780342</c:v>
                </c:pt>
                <c:pt idx="2">
                  <c:v>7.6133238678264756E-2</c:v>
                </c:pt>
                <c:pt idx="3">
                  <c:v>3.1482897569720884E-2</c:v>
                </c:pt>
                <c:pt idx="4">
                  <c:v>1.6078878068400852E-2</c:v>
                </c:pt>
                <c:pt idx="5">
                  <c:v>9.5579085961663996E-3</c:v>
                </c:pt>
                <c:pt idx="6">
                  <c:v>6.4155945287152766E-3</c:v>
                </c:pt>
                <c:pt idx="7">
                  <c:v>4.8164414788963474E-3</c:v>
                </c:pt>
                <c:pt idx="8">
                  <c:v>4.0097646146905631E-3</c:v>
                </c:pt>
                <c:pt idx="9">
                  <c:v>3.5947709086484058E-3</c:v>
                </c:pt>
                <c:pt idx="10">
                  <c:v>3.5175293849826219E-3</c:v>
                </c:pt>
                <c:pt idx="11">
                  <c:v>3.7015611108952261E-3</c:v>
                </c:pt>
                <c:pt idx="12">
                  <c:v>4.1603385250510464E-3</c:v>
                </c:pt>
                <c:pt idx="13">
                  <c:v>4.8651717223688554E-3</c:v>
                </c:pt>
                <c:pt idx="14">
                  <c:v>5.8864251683280562E-3</c:v>
                </c:pt>
                <c:pt idx="15">
                  <c:v>7.2480414681030236E-3</c:v>
                </c:pt>
                <c:pt idx="16">
                  <c:v>9.0413597711321483E-3</c:v>
                </c:pt>
                <c:pt idx="17">
                  <c:v>1.133660026894698E-2</c:v>
                </c:pt>
                <c:pt idx="18">
                  <c:v>1.4149447600747742E-2</c:v>
                </c:pt>
                <c:pt idx="19">
                  <c:v>1.7576208061895755E-2</c:v>
                </c:pt>
                <c:pt idx="20">
                  <c:v>2.1615974787575362E-2</c:v>
                </c:pt>
                <c:pt idx="21">
                  <c:v>2.6325584843096727E-2</c:v>
                </c:pt>
                <c:pt idx="22">
                  <c:v>3.1574003132767259E-2</c:v>
                </c:pt>
                <c:pt idx="23">
                  <c:v>3.7276066806158782E-2</c:v>
                </c:pt>
                <c:pt idx="24">
                  <c:v>4.3332577218762734E-2</c:v>
                </c:pt>
                <c:pt idx="25">
                  <c:v>4.9443423948246149E-2</c:v>
                </c:pt>
                <c:pt idx="26">
                  <c:v>5.5398736491633883E-2</c:v>
                </c:pt>
                <c:pt idx="27">
                  <c:v>6.0931965294965015E-2</c:v>
                </c:pt>
                <c:pt idx="28">
                  <c:v>6.5915015703010074E-2</c:v>
                </c:pt>
                <c:pt idx="29">
                  <c:v>6.9819000033089593E-2</c:v>
                </c:pt>
                <c:pt idx="30">
                  <c:v>7.2627168766863356E-2</c:v>
                </c:pt>
                <c:pt idx="31">
                  <c:v>7.4164689360149014E-2</c:v>
                </c:pt>
                <c:pt idx="32">
                  <c:v>7.4387537648252552E-2</c:v>
                </c:pt>
                <c:pt idx="33">
                  <c:v>7.3326313448518796E-2</c:v>
                </c:pt>
                <c:pt idx="34">
                  <c:v>7.0954841344673752E-2</c:v>
                </c:pt>
                <c:pt idx="35">
                  <c:v>6.7536421291755924E-2</c:v>
                </c:pt>
                <c:pt idx="36">
                  <c:v>6.3241749980772366E-2</c:v>
                </c:pt>
                <c:pt idx="37">
                  <c:v>5.8180784770637713E-2</c:v>
                </c:pt>
                <c:pt idx="38">
                  <c:v>5.2747688957382938E-2</c:v>
                </c:pt>
                <c:pt idx="39">
                  <c:v>4.7136881991173891E-2</c:v>
                </c:pt>
                <c:pt idx="40">
                  <c:v>4.1531213925587472E-2</c:v>
                </c:pt>
                <c:pt idx="41">
                  <c:v>3.6031051337092335E-2</c:v>
                </c:pt>
                <c:pt idx="42">
                  <c:v>3.0930252776943137E-2</c:v>
                </c:pt>
                <c:pt idx="43">
                  <c:v>2.6220010664125746E-2</c:v>
                </c:pt>
                <c:pt idx="44">
                  <c:v>2.1984903883088242E-2</c:v>
                </c:pt>
                <c:pt idx="45">
                  <c:v>1.8238652199263562E-2</c:v>
                </c:pt>
                <c:pt idx="46">
                  <c:v>1.507080164302255E-2</c:v>
                </c:pt>
                <c:pt idx="47">
                  <c:v>1.2452284448943911E-2</c:v>
                </c:pt>
                <c:pt idx="48">
                  <c:v>1.0269728774678535E-2</c:v>
                </c:pt>
                <c:pt idx="49">
                  <c:v>8.5142514671444486E-3</c:v>
                </c:pt>
                <c:pt idx="50">
                  <c:v>7.1325055165342467E-3</c:v>
                </c:pt>
                <c:pt idx="51">
                  <c:v>6.0957666668266961E-3</c:v>
                </c:pt>
                <c:pt idx="52">
                  <c:v>5.3410902555806536E-3</c:v>
                </c:pt>
                <c:pt idx="53">
                  <c:v>4.8184063526638824E-3</c:v>
                </c:pt>
                <c:pt idx="54">
                  <c:v>4.4739076456731348E-3</c:v>
                </c:pt>
                <c:pt idx="55">
                  <c:v>4.2878217335489913E-3</c:v>
                </c:pt>
                <c:pt idx="56">
                  <c:v>4.1993268419418528E-3</c:v>
                </c:pt>
                <c:pt idx="57">
                  <c:v>4.1857994417730544E-3</c:v>
                </c:pt>
                <c:pt idx="58">
                  <c:v>4.2322487828301246E-3</c:v>
                </c:pt>
                <c:pt idx="59">
                  <c:v>4.3232444228686502E-3</c:v>
                </c:pt>
                <c:pt idx="60">
                  <c:v>4.4218247504573902E-3</c:v>
                </c:pt>
                <c:pt idx="61">
                  <c:v>4.5187218819865514E-3</c:v>
                </c:pt>
                <c:pt idx="62">
                  <c:v>4.6191640305228744E-3</c:v>
                </c:pt>
                <c:pt idx="63">
                  <c:v>4.7164733733319293E-3</c:v>
                </c:pt>
                <c:pt idx="64">
                  <c:v>4.7752134807180924E-3</c:v>
                </c:pt>
                <c:pt idx="65">
                  <c:v>4.8043293374552005E-3</c:v>
                </c:pt>
                <c:pt idx="66">
                  <c:v>4.8214429757591831E-3</c:v>
                </c:pt>
                <c:pt idx="67">
                  <c:v>4.8064178746067077E-3</c:v>
                </c:pt>
                <c:pt idx="68">
                  <c:v>4.7515869041916499E-3</c:v>
                </c:pt>
                <c:pt idx="69">
                  <c:v>4.6727034055942581E-3</c:v>
                </c:pt>
                <c:pt idx="70">
                  <c:v>4.5504758909150561E-3</c:v>
                </c:pt>
                <c:pt idx="71">
                  <c:v>4.4035019590657086E-3</c:v>
                </c:pt>
                <c:pt idx="72">
                  <c:v>4.2491150943661134E-3</c:v>
                </c:pt>
                <c:pt idx="73">
                  <c:v>4.0816267811536432E-3</c:v>
                </c:pt>
                <c:pt idx="74">
                  <c:v>3.8713784178391786E-3</c:v>
                </c:pt>
                <c:pt idx="75">
                  <c:v>3.6746231037535766E-3</c:v>
                </c:pt>
                <c:pt idx="76">
                  <c:v>3.4475359096551232E-3</c:v>
                </c:pt>
                <c:pt idx="77">
                  <c:v>3.240166155112024E-3</c:v>
                </c:pt>
                <c:pt idx="78">
                  <c:v>3.0250399583187431E-3</c:v>
                </c:pt>
                <c:pt idx="79">
                  <c:v>2.819415231527218E-3</c:v>
                </c:pt>
                <c:pt idx="80">
                  <c:v>2.6191011600584495E-3</c:v>
                </c:pt>
                <c:pt idx="81">
                  <c:v>2.4280343616355114E-3</c:v>
                </c:pt>
                <c:pt idx="82">
                  <c:v>2.2471835327661583E-3</c:v>
                </c:pt>
                <c:pt idx="83">
                  <c:v>2.0945210852541412E-3</c:v>
                </c:pt>
                <c:pt idx="84">
                  <c:v>1.9385334667509249E-3</c:v>
                </c:pt>
                <c:pt idx="85">
                  <c:v>1.8034243495747755E-3</c:v>
                </c:pt>
                <c:pt idx="86">
                  <c:v>1.6769922798405914E-3</c:v>
                </c:pt>
                <c:pt idx="87">
                  <c:v>1.5791814133076501E-3</c:v>
                </c:pt>
                <c:pt idx="88">
                  <c:v>1.4967735082670821E-3</c:v>
                </c:pt>
                <c:pt idx="89">
                  <c:v>1.4162342943620698E-3</c:v>
                </c:pt>
                <c:pt idx="90">
                  <c:v>1.3540178718487502E-3</c:v>
                </c:pt>
                <c:pt idx="91">
                  <c:v>1.2983281279338749E-3</c:v>
                </c:pt>
                <c:pt idx="92">
                  <c:v>1.260851252402708E-3</c:v>
                </c:pt>
                <c:pt idx="93">
                  <c:v>1.2217392721279271E-3</c:v>
                </c:pt>
                <c:pt idx="94">
                  <c:v>1.1990607815452797E-3</c:v>
                </c:pt>
                <c:pt idx="95">
                  <c:v>1.1716418612437477E-3</c:v>
                </c:pt>
                <c:pt idx="96">
                  <c:v>1.1597358254425529E-3</c:v>
                </c:pt>
                <c:pt idx="97">
                  <c:v>1.1438107296623088E-3</c:v>
                </c:pt>
                <c:pt idx="98">
                  <c:v>1.1304825649454543E-3</c:v>
                </c:pt>
                <c:pt idx="99">
                  <c:v>1.1211253688916541E-3</c:v>
                </c:pt>
              </c:numCache>
            </c:numRef>
          </c:val>
        </c:ser>
        <c:marker val="1"/>
        <c:axId val="74575872"/>
        <c:axId val="74577408"/>
      </c:lineChart>
      <c:catAx>
        <c:axId val="74575872"/>
        <c:scaling>
          <c:orientation val="minMax"/>
        </c:scaling>
        <c:axPos val="b"/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fil-PH" sz="800"/>
            </a:pPr>
            <a:endParaRPr lang="ja-JP"/>
          </a:p>
        </c:txPr>
        <c:crossAx val="74577408"/>
        <c:crosses val="autoZero"/>
        <c:auto val="1"/>
        <c:lblAlgn val="ctr"/>
        <c:lblOffset val="100"/>
      </c:catAx>
      <c:valAx>
        <c:axId val="74577408"/>
        <c:scaling>
          <c:orientation val="minMax"/>
          <c:max val="8.0000000000000043E-2"/>
        </c:scaling>
        <c:axPos val="l"/>
        <c:majorGridlines/>
        <c:numFmt formatCode="General" sourceLinked="0"/>
        <c:tickLblPos val="nextTo"/>
        <c:spPr>
          <a:noFill/>
          <a:ln>
            <a:solidFill>
              <a:schemeClr val="tx1"/>
            </a:solidFill>
          </a:ln>
        </c:spPr>
        <c:txPr>
          <a:bodyPr/>
          <a:lstStyle/>
          <a:p>
            <a:pPr>
              <a:defRPr lang="fil-PH"/>
            </a:pPr>
            <a:endParaRPr lang="ja-JP"/>
          </a:p>
        </c:txPr>
        <c:crossAx val="74575872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</c:chart>
  <c:spPr>
    <a:ln>
      <a:noFill/>
    </a:ln>
  </c:spPr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ja-JP"/>
    </a:p>
  </c:txPr>
  <c:externalData r:id="rId1"/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title>
      <c:layout>
        <c:manualLayout>
          <c:xMode val="edge"/>
          <c:yMode val="edge"/>
          <c:x val="0.77066581842056536"/>
          <c:y val="4.5516907201419932E-2"/>
        </c:manualLayout>
      </c:layout>
    </c:title>
    <c:plotArea>
      <c:layout>
        <c:manualLayout>
          <c:layoutTarget val="inner"/>
          <c:xMode val="edge"/>
          <c:yMode val="edge"/>
          <c:x val="0.13179047546634318"/>
          <c:y val="1.5851032770922969E-2"/>
          <c:w val="0.85142025293998713"/>
          <c:h val="0.77528402329716373"/>
        </c:manualLayout>
      </c:layout>
      <c:lineChart>
        <c:grouping val="standard"/>
        <c:ser>
          <c:idx val="2"/>
          <c:order val="0"/>
          <c:tx>
            <c:strRef>
              <c:f>'C:\Users\USER\Desktop\Ajay''sLAB\NERICAmanuscript\[NERICAstats.xlsx]Summary'!$L$2</c:f>
              <c:strCache>
                <c:ptCount val="1"/>
                <c:pt idx="0">
                  <c:v>NERICA 4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none"/>
          </c:marker>
          <c:cat>
            <c:numRef>
              <c:f>'C:\Users\USER\Desktop\Ajay''sLAB\NERICAmanuscript\[NERICAstats.xlsx]Summary'!$B$3:$B$102</c:f>
              <c:numCache>
                <c:formatCode>General</c:formatCode>
                <c:ptCount val="100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</c:numCache>
            </c:numRef>
          </c:cat>
          <c:val>
            <c:numRef>
              <c:f>'C:\Users\USER\Desktop\Ajay''sLAB\NERICAmanuscript\[NERICAstats.xlsx]Summary'!$L$3:$L$102</c:f>
              <c:numCache>
                <c:formatCode>General</c:formatCode>
                <c:ptCount val="100"/>
                <c:pt idx="0">
                  <c:v>0</c:v>
                </c:pt>
                <c:pt idx="1">
                  <c:v>0.29927863298045387</c:v>
                </c:pt>
                <c:pt idx="2">
                  <c:v>7.9399821273488533E-2</c:v>
                </c:pt>
                <c:pt idx="3">
                  <c:v>3.2858331153494992E-2</c:v>
                </c:pt>
                <c:pt idx="4">
                  <c:v>1.6587179538407101E-2</c:v>
                </c:pt>
                <c:pt idx="5">
                  <c:v>9.5516702192170733E-3</c:v>
                </c:pt>
                <c:pt idx="6">
                  <c:v>6.1059497160934114E-3</c:v>
                </c:pt>
                <c:pt idx="7">
                  <c:v>4.2039661514522682E-3</c:v>
                </c:pt>
                <c:pt idx="8">
                  <c:v>3.1071151305132249E-3</c:v>
                </c:pt>
                <c:pt idx="9">
                  <c:v>2.4392049006042027E-3</c:v>
                </c:pt>
                <c:pt idx="10">
                  <c:v>2.0111249837187562E-3</c:v>
                </c:pt>
                <c:pt idx="11">
                  <c:v>1.7260475355970475E-3</c:v>
                </c:pt>
                <c:pt idx="12">
                  <c:v>1.5547335808290979E-3</c:v>
                </c:pt>
                <c:pt idx="13">
                  <c:v>1.4678262862351593E-3</c:v>
                </c:pt>
                <c:pt idx="14">
                  <c:v>1.4471704310165263E-3</c:v>
                </c:pt>
                <c:pt idx="15">
                  <c:v>1.4933706767747141E-3</c:v>
                </c:pt>
                <c:pt idx="16">
                  <c:v>1.581149094014928E-3</c:v>
                </c:pt>
                <c:pt idx="17">
                  <c:v>1.7302647940552261E-3</c:v>
                </c:pt>
                <c:pt idx="18">
                  <c:v>1.9477072550693161E-3</c:v>
                </c:pt>
                <c:pt idx="19">
                  <c:v>2.2223158586830538E-3</c:v>
                </c:pt>
                <c:pt idx="20">
                  <c:v>2.5704728348974089E-3</c:v>
                </c:pt>
                <c:pt idx="21">
                  <c:v>2.9845379256794214E-3</c:v>
                </c:pt>
                <c:pt idx="22">
                  <c:v>3.485582050567408E-3</c:v>
                </c:pt>
                <c:pt idx="23">
                  <c:v>4.1070768161820858E-3</c:v>
                </c:pt>
                <c:pt idx="24">
                  <c:v>4.8572773906597434E-3</c:v>
                </c:pt>
                <c:pt idx="25">
                  <c:v>5.7610978816840831E-3</c:v>
                </c:pt>
                <c:pt idx="26">
                  <c:v>6.8406801772232404E-3</c:v>
                </c:pt>
                <c:pt idx="27">
                  <c:v>8.0987606272367677E-3</c:v>
                </c:pt>
                <c:pt idx="28">
                  <c:v>9.5549343670151728E-3</c:v>
                </c:pt>
                <c:pt idx="29">
                  <c:v>1.124176601077688E-2</c:v>
                </c:pt>
                <c:pt idx="30">
                  <c:v>1.317491526915154E-2</c:v>
                </c:pt>
                <c:pt idx="31">
                  <c:v>1.5318988941445736E-2</c:v>
                </c:pt>
                <c:pt idx="32">
                  <c:v>1.7727596940161947E-2</c:v>
                </c:pt>
                <c:pt idx="33">
                  <c:v>2.0280990646941346E-2</c:v>
                </c:pt>
                <c:pt idx="34">
                  <c:v>2.3014004719133532E-2</c:v>
                </c:pt>
                <c:pt idx="35">
                  <c:v>2.5887669228944549E-2</c:v>
                </c:pt>
                <c:pt idx="36">
                  <c:v>2.8794251926283248E-2</c:v>
                </c:pt>
                <c:pt idx="37">
                  <c:v>3.1694132103496482E-2</c:v>
                </c:pt>
                <c:pt idx="38">
                  <c:v>3.4515360154252044E-2</c:v>
                </c:pt>
                <c:pt idx="39">
                  <c:v>3.7111864183520825E-2</c:v>
                </c:pt>
                <c:pt idx="40">
                  <c:v>3.9487769213245295E-2</c:v>
                </c:pt>
                <c:pt idx="41">
                  <c:v>4.1472796387331583E-2</c:v>
                </c:pt>
                <c:pt idx="42">
                  <c:v>4.3084424525464703E-2</c:v>
                </c:pt>
                <c:pt idx="43">
                  <c:v>4.4208413578960895E-2</c:v>
                </c:pt>
                <c:pt idx="44">
                  <c:v>4.4774171867966034E-2</c:v>
                </c:pt>
                <c:pt idx="45">
                  <c:v>4.4818137940349299E-2</c:v>
                </c:pt>
                <c:pt idx="46">
                  <c:v>4.4311979813102496E-2</c:v>
                </c:pt>
                <c:pt idx="47">
                  <c:v>4.3342158970994776E-2</c:v>
                </c:pt>
                <c:pt idx="48">
                  <c:v>4.1833200323102504E-2</c:v>
                </c:pt>
                <c:pt idx="49">
                  <c:v>3.9928782739302587E-2</c:v>
                </c:pt>
                <c:pt idx="50">
                  <c:v>3.7756453947763668E-2</c:v>
                </c:pt>
                <c:pt idx="51">
                  <c:v>3.5242163399300683E-2</c:v>
                </c:pt>
                <c:pt idx="52">
                  <c:v>3.253928504641914E-2</c:v>
                </c:pt>
                <c:pt idx="53">
                  <c:v>2.9768674345663423E-2</c:v>
                </c:pt>
                <c:pt idx="54">
                  <c:v>2.6943254657704016E-2</c:v>
                </c:pt>
                <c:pt idx="55">
                  <c:v>2.4092398188473189E-2</c:v>
                </c:pt>
                <c:pt idx="56">
                  <c:v>2.1385179595112592E-2</c:v>
                </c:pt>
                <c:pt idx="57">
                  <c:v>1.87551988349723E-2</c:v>
                </c:pt>
                <c:pt idx="58">
                  <c:v>1.634068769926485E-2</c:v>
                </c:pt>
                <c:pt idx="59">
                  <c:v>1.407540499711654E-2</c:v>
                </c:pt>
                <c:pt idx="60">
                  <c:v>1.2065976140432607E-2</c:v>
                </c:pt>
                <c:pt idx="61">
                  <c:v>1.0275286180230454E-2</c:v>
                </c:pt>
                <c:pt idx="62">
                  <c:v>8.6809626372532228E-3</c:v>
                </c:pt>
                <c:pt idx="63">
                  <c:v>7.3169434249499036E-3</c:v>
                </c:pt>
                <c:pt idx="64">
                  <c:v>6.148542489245826E-3</c:v>
                </c:pt>
                <c:pt idx="65">
                  <c:v>5.1628108482165208E-3</c:v>
                </c:pt>
                <c:pt idx="66">
                  <c:v>4.3365356454640397E-3</c:v>
                </c:pt>
                <c:pt idx="67">
                  <c:v>3.6940365755721923E-3</c:v>
                </c:pt>
                <c:pt idx="68">
                  <c:v>3.1576709895028351E-3</c:v>
                </c:pt>
                <c:pt idx="69">
                  <c:v>2.7494270476983627E-3</c:v>
                </c:pt>
                <c:pt idx="70">
                  <c:v>2.434311241032449E-3</c:v>
                </c:pt>
                <c:pt idx="71">
                  <c:v>2.2023210318254213E-3</c:v>
                </c:pt>
                <c:pt idx="72">
                  <c:v>2.0444121173085082E-3</c:v>
                </c:pt>
                <c:pt idx="73">
                  <c:v>1.9318681956595367E-3</c:v>
                </c:pt>
                <c:pt idx="74">
                  <c:v>1.881788891999958E-3</c:v>
                </c:pt>
                <c:pt idx="75">
                  <c:v>1.8690038861030327E-3</c:v>
                </c:pt>
                <c:pt idx="76">
                  <c:v>1.8814968097009095E-3</c:v>
                </c:pt>
                <c:pt idx="77">
                  <c:v>1.9245661381833417E-3</c:v>
                </c:pt>
                <c:pt idx="78">
                  <c:v>1.9790061793252016E-3</c:v>
                </c:pt>
                <c:pt idx="79">
                  <c:v>2.0543941579847535E-3</c:v>
                </c:pt>
                <c:pt idx="80">
                  <c:v>2.1323493863254E-3</c:v>
                </c:pt>
                <c:pt idx="81">
                  <c:v>2.2149881799525487E-3</c:v>
                </c:pt>
                <c:pt idx="82">
                  <c:v>2.3029920642306219E-3</c:v>
                </c:pt>
                <c:pt idx="83">
                  <c:v>2.3888796329033192E-3</c:v>
                </c:pt>
                <c:pt idx="84">
                  <c:v>2.4765196953703003E-3</c:v>
                </c:pt>
                <c:pt idx="85">
                  <c:v>2.553076003226041E-3</c:v>
                </c:pt>
                <c:pt idx="86">
                  <c:v>2.6232167490044598E-3</c:v>
                </c:pt>
                <c:pt idx="87">
                  <c:v>2.6900779742321402E-3</c:v>
                </c:pt>
                <c:pt idx="88">
                  <c:v>2.7457529598313851E-3</c:v>
                </c:pt>
                <c:pt idx="89">
                  <c:v>2.7855888860208412E-3</c:v>
                </c:pt>
                <c:pt idx="90">
                  <c:v>2.8189836288786572E-3</c:v>
                </c:pt>
                <c:pt idx="91">
                  <c:v>2.8358065444536503E-3</c:v>
                </c:pt>
                <c:pt idx="92">
                  <c:v>2.8389425859802714E-3</c:v>
                </c:pt>
                <c:pt idx="93">
                  <c:v>2.8377127657737552E-3</c:v>
                </c:pt>
                <c:pt idx="94">
                  <c:v>2.8159551966201067E-3</c:v>
                </c:pt>
                <c:pt idx="95">
                  <c:v>2.7787172656169325E-3</c:v>
                </c:pt>
                <c:pt idx="96">
                  <c:v>2.7354993338595326E-3</c:v>
                </c:pt>
                <c:pt idx="97">
                  <c:v>2.6769137737715416E-3</c:v>
                </c:pt>
                <c:pt idx="98">
                  <c:v>2.6144696527855946E-3</c:v>
                </c:pt>
                <c:pt idx="99">
                  <c:v>2.5309341152578639E-3</c:v>
                </c:pt>
              </c:numCache>
            </c:numRef>
          </c:val>
        </c:ser>
        <c:marker val="1"/>
        <c:axId val="75812224"/>
        <c:axId val="75854976"/>
      </c:lineChart>
      <c:catAx>
        <c:axId val="75812224"/>
        <c:scaling>
          <c:orientation val="minMax"/>
        </c:scaling>
        <c:axPos val="b"/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fil-PH" sz="800"/>
            </a:pPr>
            <a:endParaRPr lang="ja-JP"/>
          </a:p>
        </c:txPr>
        <c:crossAx val="75854976"/>
        <c:crosses val="autoZero"/>
        <c:auto val="1"/>
        <c:lblAlgn val="ctr"/>
        <c:lblOffset val="100"/>
      </c:catAx>
      <c:valAx>
        <c:axId val="75854976"/>
        <c:scaling>
          <c:orientation val="minMax"/>
          <c:max val="0.05"/>
        </c:scaling>
        <c:axPos val="l"/>
        <c:majorGridlines/>
        <c:numFmt formatCode="General" sourceLinked="0"/>
        <c:tickLblPos val="nextTo"/>
        <c:spPr>
          <a:noFill/>
          <a:ln>
            <a:solidFill>
              <a:schemeClr val="tx1"/>
            </a:solidFill>
          </a:ln>
        </c:spPr>
        <c:txPr>
          <a:bodyPr/>
          <a:lstStyle/>
          <a:p>
            <a:pPr>
              <a:defRPr lang="fil-PH"/>
            </a:pPr>
            <a:endParaRPr lang="ja-JP"/>
          </a:p>
        </c:txPr>
        <c:crossAx val="75812224"/>
        <c:crosses val="autoZero"/>
        <c:crossBetween val="between"/>
        <c:majorUnit val="1.0000000000000005E-2"/>
      </c:valAx>
      <c:spPr>
        <a:ln>
          <a:solidFill>
            <a:schemeClr val="tx1"/>
          </a:solidFill>
        </a:ln>
      </c:spPr>
    </c:plotArea>
    <c:plotVisOnly val="1"/>
    <c:dispBlanksAs val="gap"/>
  </c:chart>
  <c:spPr>
    <a:ln>
      <a:noFill/>
    </a:ln>
  </c:spPr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ja-JP"/>
    </a:p>
  </c:txPr>
  <c:externalData r:id="rId1"/>
  <c:userShapes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title>
      <c:layout>
        <c:manualLayout>
          <c:xMode val="edge"/>
          <c:yMode val="edge"/>
          <c:x val="0.77293407898976363"/>
          <c:y val="3.1861835040994005E-2"/>
        </c:manualLayout>
      </c:layout>
    </c:title>
    <c:plotArea>
      <c:layout>
        <c:manualLayout>
          <c:layoutTarget val="inner"/>
          <c:xMode val="edge"/>
          <c:yMode val="edge"/>
          <c:x val="0.13179047546634318"/>
          <c:y val="1.5851032770922969E-2"/>
          <c:w val="0.85142025293998713"/>
          <c:h val="0.77528402329716373"/>
        </c:manualLayout>
      </c:layout>
      <c:lineChart>
        <c:grouping val="standard"/>
        <c:ser>
          <c:idx val="3"/>
          <c:order val="0"/>
          <c:tx>
            <c:strRef>
              <c:f>'C:\Users\USER\Desktop\Ajay''sLAB\NERICAmanuscript\[NERICAstats.xlsx]Summary'!$M$2</c:f>
              <c:strCache>
                <c:ptCount val="1"/>
                <c:pt idx="0">
                  <c:v>NERICA 5</c:v>
                </c:pt>
              </c:strCache>
            </c:strRef>
          </c:tx>
          <c:spPr>
            <a:ln>
              <a:solidFill>
                <a:sysClr val="windowText" lastClr="000000"/>
              </a:solidFill>
            </a:ln>
          </c:spPr>
          <c:marker>
            <c:symbol val="none"/>
          </c:marker>
          <c:cat>
            <c:numRef>
              <c:f>'C:\Users\USER\Desktop\Ajay''sLAB\NERICAmanuscript\[NERICAstats.xlsx]Summary'!$B$3:$B$102</c:f>
              <c:numCache>
                <c:formatCode>General</c:formatCode>
                <c:ptCount val="100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</c:numCache>
            </c:numRef>
          </c:cat>
          <c:val>
            <c:numRef>
              <c:f>'C:\Users\USER\Desktop\Ajay''sLAB\NERICAmanuscript\[NERICAstats.xlsx]Summary'!$M$3:$M$102</c:f>
              <c:numCache>
                <c:formatCode>General</c:formatCode>
                <c:ptCount val="100"/>
                <c:pt idx="0">
                  <c:v>0</c:v>
                </c:pt>
                <c:pt idx="1">
                  <c:v>0.31426876036785067</c:v>
                </c:pt>
                <c:pt idx="2">
                  <c:v>8.3222318762754557E-2</c:v>
                </c:pt>
                <c:pt idx="3">
                  <c:v>3.3875336335080199E-2</c:v>
                </c:pt>
                <c:pt idx="4">
                  <c:v>1.7040127730999062E-2</c:v>
                </c:pt>
                <c:pt idx="5">
                  <c:v>9.8849733285440548E-3</c:v>
                </c:pt>
                <c:pt idx="6">
                  <c:v>6.571090137187232E-3</c:v>
                </c:pt>
                <c:pt idx="7">
                  <c:v>5.070785972605683E-3</c:v>
                </c:pt>
                <c:pt idx="8">
                  <c:v>4.5420379662919445E-3</c:v>
                </c:pt>
                <c:pt idx="9">
                  <c:v>4.6025247812239893E-3</c:v>
                </c:pt>
                <c:pt idx="10">
                  <c:v>5.0193454581325819E-3</c:v>
                </c:pt>
                <c:pt idx="11">
                  <c:v>5.6688976391144289E-3</c:v>
                </c:pt>
                <c:pt idx="12">
                  <c:v>6.3812829377410188E-3</c:v>
                </c:pt>
                <c:pt idx="13">
                  <c:v>7.0389472431017482E-3</c:v>
                </c:pt>
                <c:pt idx="14">
                  <c:v>7.5395613418883737E-3</c:v>
                </c:pt>
                <c:pt idx="15">
                  <c:v>7.8396143537956334E-3</c:v>
                </c:pt>
                <c:pt idx="16">
                  <c:v>7.9016479905160419E-3</c:v>
                </c:pt>
                <c:pt idx="17">
                  <c:v>7.7205003860816258E-3</c:v>
                </c:pt>
                <c:pt idx="18">
                  <c:v>7.3130084349584826E-3</c:v>
                </c:pt>
                <c:pt idx="19">
                  <c:v>6.7473322309500924E-3</c:v>
                </c:pt>
                <c:pt idx="20">
                  <c:v>6.1197701203921382E-3</c:v>
                </c:pt>
                <c:pt idx="21">
                  <c:v>5.4726033471681618E-3</c:v>
                </c:pt>
                <c:pt idx="22">
                  <c:v>4.8643721639596979E-3</c:v>
                </c:pt>
                <c:pt idx="23">
                  <c:v>4.3516441911675939E-3</c:v>
                </c:pt>
                <c:pt idx="24">
                  <c:v>3.9413323317841892E-3</c:v>
                </c:pt>
                <c:pt idx="25">
                  <c:v>3.6756265845876252E-3</c:v>
                </c:pt>
                <c:pt idx="26">
                  <c:v>3.5321154136667148E-3</c:v>
                </c:pt>
                <c:pt idx="27">
                  <c:v>3.5556218908438051E-3</c:v>
                </c:pt>
                <c:pt idx="28">
                  <c:v>3.7227959591226551E-3</c:v>
                </c:pt>
                <c:pt idx="29">
                  <c:v>4.0148585067917046E-3</c:v>
                </c:pt>
                <c:pt idx="30">
                  <c:v>4.4286941652491706E-3</c:v>
                </c:pt>
                <c:pt idx="31">
                  <c:v>4.9677398334685525E-3</c:v>
                </c:pt>
                <c:pt idx="32">
                  <c:v>5.6320737215403557E-3</c:v>
                </c:pt>
                <c:pt idx="33">
                  <c:v>6.4151870119393247E-3</c:v>
                </c:pt>
                <c:pt idx="34">
                  <c:v>7.3157848931684798E-3</c:v>
                </c:pt>
                <c:pt idx="35">
                  <c:v>8.3404891528836862E-3</c:v>
                </c:pt>
                <c:pt idx="36">
                  <c:v>9.4911768332549568E-3</c:v>
                </c:pt>
                <c:pt idx="37">
                  <c:v>1.0775403898018267E-2</c:v>
                </c:pt>
                <c:pt idx="38">
                  <c:v>1.2206166257198789E-2</c:v>
                </c:pt>
                <c:pt idx="39">
                  <c:v>1.3749707566769119E-2</c:v>
                </c:pt>
                <c:pt idx="40">
                  <c:v>1.538521959767164E-2</c:v>
                </c:pt>
                <c:pt idx="41">
                  <c:v>1.7153028341529465E-2</c:v>
                </c:pt>
                <c:pt idx="42">
                  <c:v>1.8950322289476705E-2</c:v>
                </c:pt>
                <c:pt idx="43">
                  <c:v>2.0834325157672813E-2</c:v>
                </c:pt>
                <c:pt idx="44">
                  <c:v>2.2731936581602465E-2</c:v>
                </c:pt>
                <c:pt idx="45">
                  <c:v>2.4507822689798855E-2</c:v>
                </c:pt>
                <c:pt idx="46">
                  <c:v>2.6310443613904892E-2</c:v>
                </c:pt>
                <c:pt idx="47">
                  <c:v>2.7923000983268404E-2</c:v>
                </c:pt>
                <c:pt idx="48">
                  <c:v>2.9459438209625242E-2</c:v>
                </c:pt>
                <c:pt idx="49">
                  <c:v>3.0724104061772766E-2</c:v>
                </c:pt>
                <c:pt idx="50">
                  <c:v>3.1757285426288792E-2</c:v>
                </c:pt>
                <c:pt idx="51">
                  <c:v>3.2533820379082201E-2</c:v>
                </c:pt>
                <c:pt idx="52">
                  <c:v>3.2998688121540519E-2</c:v>
                </c:pt>
                <c:pt idx="53">
                  <c:v>3.3209807570627088E-2</c:v>
                </c:pt>
                <c:pt idx="54">
                  <c:v>3.3102916102044036E-2</c:v>
                </c:pt>
                <c:pt idx="55">
                  <c:v>3.2647811585873689E-2</c:v>
                </c:pt>
                <c:pt idx="56">
                  <c:v>3.1958576474012054E-2</c:v>
                </c:pt>
                <c:pt idx="57">
                  <c:v>3.0981072003867183E-2</c:v>
                </c:pt>
                <c:pt idx="58">
                  <c:v>2.976001696714034E-2</c:v>
                </c:pt>
                <c:pt idx="59">
                  <c:v>2.8379196095699801E-2</c:v>
                </c:pt>
                <c:pt idx="60">
                  <c:v>2.6777657659076026E-2</c:v>
                </c:pt>
                <c:pt idx="61">
                  <c:v>2.5085465037641932E-2</c:v>
                </c:pt>
                <c:pt idx="62">
                  <c:v>2.3317886579050352E-2</c:v>
                </c:pt>
                <c:pt idx="63">
                  <c:v>2.1449973264456405E-2</c:v>
                </c:pt>
                <c:pt idx="64">
                  <c:v>1.9595916170882167E-2</c:v>
                </c:pt>
                <c:pt idx="65">
                  <c:v>1.7776614772490932E-2</c:v>
                </c:pt>
                <c:pt idx="66">
                  <c:v>1.5983687554592313E-2</c:v>
                </c:pt>
                <c:pt idx="67">
                  <c:v>1.4272511606210701E-2</c:v>
                </c:pt>
                <c:pt idx="68">
                  <c:v>1.2653671359583297E-2</c:v>
                </c:pt>
                <c:pt idx="69">
                  <c:v>1.116006284774294E-2</c:v>
                </c:pt>
                <c:pt idx="70">
                  <c:v>9.7771911339313029E-3</c:v>
                </c:pt>
                <c:pt idx="71">
                  <c:v>8.5085800172224682E-3</c:v>
                </c:pt>
                <c:pt idx="72">
                  <c:v>7.3876816912922128E-3</c:v>
                </c:pt>
                <c:pt idx="73">
                  <c:v>6.378254469239647E-3</c:v>
                </c:pt>
                <c:pt idx="74">
                  <c:v>5.5027576820311994E-3</c:v>
                </c:pt>
                <c:pt idx="75">
                  <c:v>4.7131659891421918E-3</c:v>
                </c:pt>
                <c:pt idx="76">
                  <c:v>4.0458383926092094E-3</c:v>
                </c:pt>
                <c:pt idx="77">
                  <c:v>3.4814743801179293E-3</c:v>
                </c:pt>
                <c:pt idx="78">
                  <c:v>3.0122920476712452E-3</c:v>
                </c:pt>
                <c:pt idx="79">
                  <c:v>2.6027492541770159E-3</c:v>
                </c:pt>
                <c:pt idx="80">
                  <c:v>2.2747795849938101E-3</c:v>
                </c:pt>
                <c:pt idx="81">
                  <c:v>2.0126845369717685E-3</c:v>
                </c:pt>
                <c:pt idx="82">
                  <c:v>1.7917714465623821E-3</c:v>
                </c:pt>
                <c:pt idx="83">
                  <c:v>1.6312669609946015E-3</c:v>
                </c:pt>
                <c:pt idx="84">
                  <c:v>1.4999478741696101E-3</c:v>
                </c:pt>
                <c:pt idx="85">
                  <c:v>1.4109795513085961E-3</c:v>
                </c:pt>
                <c:pt idx="86">
                  <c:v>1.347994358488056E-3</c:v>
                </c:pt>
                <c:pt idx="87">
                  <c:v>1.3098278343617136E-3</c:v>
                </c:pt>
                <c:pt idx="88">
                  <c:v>1.2954936627892085E-3</c:v>
                </c:pt>
                <c:pt idx="89">
                  <c:v>1.2994649973806778E-3</c:v>
                </c:pt>
                <c:pt idx="90">
                  <c:v>1.3176358083889241E-3</c:v>
                </c:pt>
                <c:pt idx="91">
                  <c:v>1.3351679036587179E-3</c:v>
                </c:pt>
                <c:pt idx="92">
                  <c:v>1.3723133516045458E-3</c:v>
                </c:pt>
                <c:pt idx="93">
                  <c:v>1.4184225449138401E-3</c:v>
                </c:pt>
                <c:pt idx="94">
                  <c:v>1.4644839431678742E-3</c:v>
                </c:pt>
                <c:pt idx="95">
                  <c:v>1.5192483864839626E-3</c:v>
                </c:pt>
                <c:pt idx="96">
                  <c:v>1.5769283281708121E-3</c:v>
                </c:pt>
                <c:pt idx="97">
                  <c:v>1.628247182503279E-3</c:v>
                </c:pt>
                <c:pt idx="98">
                  <c:v>1.6778497598514558E-3</c:v>
                </c:pt>
                <c:pt idx="99">
                  <c:v>1.7336135543229449E-3</c:v>
                </c:pt>
              </c:numCache>
            </c:numRef>
          </c:val>
        </c:ser>
        <c:marker val="1"/>
        <c:axId val="75870592"/>
        <c:axId val="75872128"/>
      </c:lineChart>
      <c:catAx>
        <c:axId val="75870592"/>
        <c:scaling>
          <c:orientation val="minMax"/>
        </c:scaling>
        <c:axPos val="b"/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fil-PH" sz="800"/>
            </a:pPr>
            <a:endParaRPr lang="ja-JP"/>
          </a:p>
        </c:txPr>
        <c:crossAx val="75872128"/>
        <c:crosses val="autoZero"/>
        <c:auto val="1"/>
        <c:lblAlgn val="ctr"/>
        <c:lblOffset val="100"/>
      </c:catAx>
      <c:valAx>
        <c:axId val="75872128"/>
        <c:scaling>
          <c:orientation val="minMax"/>
          <c:max val="4.0000000000000022E-2"/>
        </c:scaling>
        <c:axPos val="l"/>
        <c:majorGridlines/>
        <c:numFmt formatCode="General" sourceLinked="0"/>
        <c:tickLblPos val="nextTo"/>
        <c:spPr>
          <a:noFill/>
          <a:ln>
            <a:solidFill>
              <a:schemeClr val="tx1"/>
            </a:solidFill>
          </a:ln>
        </c:spPr>
        <c:txPr>
          <a:bodyPr/>
          <a:lstStyle/>
          <a:p>
            <a:pPr>
              <a:defRPr lang="fil-PH"/>
            </a:pPr>
            <a:endParaRPr lang="ja-JP"/>
          </a:p>
        </c:txPr>
        <c:crossAx val="75870592"/>
        <c:crosses val="autoZero"/>
        <c:crossBetween val="between"/>
        <c:majorUnit val="1.0000000000000005E-2"/>
      </c:valAx>
      <c:spPr>
        <a:ln>
          <a:solidFill>
            <a:schemeClr val="tx1"/>
          </a:solidFill>
        </a:ln>
      </c:spPr>
    </c:plotArea>
    <c:plotVisOnly val="1"/>
    <c:dispBlanksAs val="gap"/>
  </c:chart>
  <c:spPr>
    <a:ln>
      <a:noFill/>
    </a:ln>
  </c:spPr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ja-JP"/>
    </a:p>
  </c:txPr>
  <c:externalData r:id="rId1"/>
  <c:userShapes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title>
      <c:layout>
        <c:manualLayout>
          <c:xMode val="edge"/>
          <c:yMode val="edge"/>
          <c:x val="0.7774706001281676"/>
          <c:y val="3.6413525761135872E-2"/>
        </c:manualLayout>
      </c:layout>
    </c:title>
    <c:plotArea>
      <c:layout>
        <c:manualLayout>
          <c:layoutTarget val="inner"/>
          <c:xMode val="edge"/>
          <c:yMode val="edge"/>
          <c:x val="0.13179047546634323"/>
          <c:y val="1.5851032770922969E-2"/>
          <c:w val="0.85142025293998724"/>
          <c:h val="0.77528402329716373"/>
        </c:manualLayout>
      </c:layout>
      <c:lineChart>
        <c:grouping val="standard"/>
        <c:ser>
          <c:idx val="4"/>
          <c:order val="0"/>
          <c:tx>
            <c:strRef>
              <c:f>[1]Summary!$N$2</c:f>
              <c:strCache>
                <c:ptCount val="1"/>
                <c:pt idx="0">
                  <c:v>NERICA 7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none"/>
          </c:marker>
          <c:cat>
            <c:numRef>
              <c:f>[1]Summary!$B$3:$B$102</c:f>
              <c:numCache>
                <c:formatCode>General</c:formatCode>
                <c:ptCount val="100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</c:numCache>
            </c:numRef>
          </c:cat>
          <c:val>
            <c:numRef>
              <c:f>[1]Summary!$N$3:$N$102</c:f>
              <c:numCache>
                <c:formatCode>General</c:formatCode>
                <c:ptCount val="100"/>
                <c:pt idx="0">
                  <c:v>0</c:v>
                </c:pt>
                <c:pt idx="1">
                  <c:v>0.33980463055715376</c:v>
                </c:pt>
                <c:pt idx="2">
                  <c:v>9.396011409448661E-2</c:v>
                </c:pt>
                <c:pt idx="3">
                  <c:v>4.0719569449246651E-2</c:v>
                </c:pt>
                <c:pt idx="4">
                  <c:v>2.415738148888635E-2</c:v>
                </c:pt>
                <c:pt idx="5">
                  <c:v>1.8222174389082701E-2</c:v>
                </c:pt>
                <c:pt idx="6">
                  <c:v>1.5639604800434238E-2</c:v>
                </c:pt>
                <c:pt idx="7">
                  <c:v>1.4363793188995999E-2</c:v>
                </c:pt>
                <c:pt idx="8">
                  <c:v>1.3786849375520761E-2</c:v>
                </c:pt>
                <c:pt idx="9">
                  <c:v>1.3704726667314617E-2</c:v>
                </c:pt>
                <c:pt idx="10">
                  <c:v>1.3914838916431301E-2</c:v>
                </c:pt>
                <c:pt idx="11">
                  <c:v>1.435336890883592E-2</c:v>
                </c:pt>
                <c:pt idx="12">
                  <c:v>1.490563237988822E-2</c:v>
                </c:pt>
                <c:pt idx="13">
                  <c:v>1.5428782325636287E-2</c:v>
                </c:pt>
                <c:pt idx="14">
                  <c:v>1.593834061379102E-2</c:v>
                </c:pt>
                <c:pt idx="15">
                  <c:v>1.6365008691793723E-2</c:v>
                </c:pt>
                <c:pt idx="16">
                  <c:v>1.6699038139406781E-2</c:v>
                </c:pt>
                <c:pt idx="17">
                  <c:v>1.7068000380809037E-2</c:v>
                </c:pt>
                <c:pt idx="18">
                  <c:v>1.7493522933519419E-2</c:v>
                </c:pt>
                <c:pt idx="19">
                  <c:v>1.8034153595228242E-2</c:v>
                </c:pt>
                <c:pt idx="20">
                  <c:v>1.8743313937942679E-2</c:v>
                </c:pt>
                <c:pt idx="21">
                  <c:v>1.9623002903297829E-2</c:v>
                </c:pt>
                <c:pt idx="22">
                  <c:v>2.0740634654746518E-2</c:v>
                </c:pt>
                <c:pt idx="23">
                  <c:v>2.2038073783703808E-2</c:v>
                </c:pt>
                <c:pt idx="24">
                  <c:v>2.3622759107335634E-2</c:v>
                </c:pt>
                <c:pt idx="25">
                  <c:v>2.5458033816288427E-2</c:v>
                </c:pt>
                <c:pt idx="26">
                  <c:v>2.7524601537012798E-2</c:v>
                </c:pt>
                <c:pt idx="27">
                  <c:v>2.9769258347307183E-2</c:v>
                </c:pt>
                <c:pt idx="28">
                  <c:v>3.2244841601279807E-2</c:v>
                </c:pt>
                <c:pt idx="29">
                  <c:v>3.4823235750237581E-2</c:v>
                </c:pt>
                <c:pt idx="30">
                  <c:v>3.7424397214380282E-2</c:v>
                </c:pt>
                <c:pt idx="31">
                  <c:v>4.0069438024845298E-2</c:v>
                </c:pt>
                <c:pt idx="32">
                  <c:v>4.2609554446160283E-2</c:v>
                </c:pt>
                <c:pt idx="33">
                  <c:v>4.4988821933554794E-2</c:v>
                </c:pt>
                <c:pt idx="34">
                  <c:v>4.7036121918862528E-2</c:v>
                </c:pt>
                <c:pt idx="35">
                  <c:v>4.8630372378685241E-2</c:v>
                </c:pt>
                <c:pt idx="36">
                  <c:v>4.9699691600930636E-2</c:v>
                </c:pt>
                <c:pt idx="37">
                  <c:v>5.0146217359875504E-2</c:v>
                </c:pt>
                <c:pt idx="38">
                  <c:v>4.9987350184710573E-2</c:v>
                </c:pt>
                <c:pt idx="39">
                  <c:v>4.921531768632733E-2</c:v>
                </c:pt>
                <c:pt idx="40">
                  <c:v>4.7787827070933597E-2</c:v>
                </c:pt>
                <c:pt idx="41">
                  <c:v>4.5895396377520589E-2</c:v>
                </c:pt>
                <c:pt idx="42">
                  <c:v>4.3502342493233058E-2</c:v>
                </c:pt>
                <c:pt idx="43">
                  <c:v>4.0793347005698324E-2</c:v>
                </c:pt>
                <c:pt idx="44">
                  <c:v>3.7757521697012381E-2</c:v>
                </c:pt>
                <c:pt idx="45">
                  <c:v>3.4551259407709388E-2</c:v>
                </c:pt>
                <c:pt idx="46">
                  <c:v>3.128962815340209E-2</c:v>
                </c:pt>
                <c:pt idx="47">
                  <c:v>2.8025568385475201E-2</c:v>
                </c:pt>
                <c:pt idx="48">
                  <c:v>2.4861278142882581E-2</c:v>
                </c:pt>
                <c:pt idx="49">
                  <c:v>2.1892500429556171E-2</c:v>
                </c:pt>
                <c:pt idx="50">
                  <c:v>1.9124636397249029E-2</c:v>
                </c:pt>
                <c:pt idx="51">
                  <c:v>1.6587887820293301E-2</c:v>
                </c:pt>
                <c:pt idx="52">
                  <c:v>1.4335521624781643E-2</c:v>
                </c:pt>
                <c:pt idx="53">
                  <c:v>1.2338939771791308E-2</c:v>
                </c:pt>
                <c:pt idx="54">
                  <c:v>1.0606355677668371E-2</c:v>
                </c:pt>
                <c:pt idx="55">
                  <c:v>9.148474276269327E-3</c:v>
                </c:pt>
                <c:pt idx="56">
                  <c:v>7.9091705558972034E-3</c:v>
                </c:pt>
                <c:pt idx="57">
                  <c:v>6.8975056216142505E-3</c:v>
                </c:pt>
                <c:pt idx="58">
                  <c:v>6.0745144306023164E-3</c:v>
                </c:pt>
                <c:pt idx="59">
                  <c:v>5.3959625236985774E-3</c:v>
                </c:pt>
                <c:pt idx="60">
                  <c:v>4.8742903055776108E-3</c:v>
                </c:pt>
                <c:pt idx="61">
                  <c:v>4.4753038462637387E-3</c:v>
                </c:pt>
                <c:pt idx="62">
                  <c:v>4.1660349278440784E-3</c:v>
                </c:pt>
                <c:pt idx="63">
                  <c:v>3.9226508966120422E-3</c:v>
                </c:pt>
                <c:pt idx="64">
                  <c:v>3.7473110677436199E-3</c:v>
                </c:pt>
                <c:pt idx="65">
                  <c:v>3.6203582272226254E-3</c:v>
                </c:pt>
                <c:pt idx="66">
                  <c:v>3.5414086240761551E-3</c:v>
                </c:pt>
                <c:pt idx="67">
                  <c:v>3.4947685617994903E-3</c:v>
                </c:pt>
                <c:pt idx="68">
                  <c:v>3.4540050442724039E-3</c:v>
                </c:pt>
                <c:pt idx="69">
                  <c:v>3.4324863516562352E-3</c:v>
                </c:pt>
                <c:pt idx="70">
                  <c:v>3.422463005348461E-3</c:v>
                </c:pt>
                <c:pt idx="71">
                  <c:v>3.4187400481484409E-3</c:v>
                </c:pt>
                <c:pt idx="72">
                  <c:v>3.4145073321933291E-3</c:v>
                </c:pt>
                <c:pt idx="73">
                  <c:v>3.4015113477520085E-3</c:v>
                </c:pt>
                <c:pt idx="74">
                  <c:v>3.3985329819919766E-3</c:v>
                </c:pt>
                <c:pt idx="75">
                  <c:v>3.3725181026034571E-3</c:v>
                </c:pt>
                <c:pt idx="76">
                  <c:v>3.3605416356722881E-3</c:v>
                </c:pt>
                <c:pt idx="77">
                  <c:v>3.3312677368271411E-3</c:v>
                </c:pt>
                <c:pt idx="78">
                  <c:v>3.2913175422576118E-3</c:v>
                </c:pt>
                <c:pt idx="79">
                  <c:v>3.2327239235556003E-3</c:v>
                </c:pt>
                <c:pt idx="80">
                  <c:v>3.1721542737243656E-3</c:v>
                </c:pt>
                <c:pt idx="81">
                  <c:v>3.1084401569657183E-3</c:v>
                </c:pt>
                <c:pt idx="82">
                  <c:v>3.0213974176290432E-3</c:v>
                </c:pt>
                <c:pt idx="83">
                  <c:v>2.9455063670130602E-3</c:v>
                </c:pt>
                <c:pt idx="84">
                  <c:v>2.8554165303988177E-3</c:v>
                </c:pt>
                <c:pt idx="85">
                  <c:v>2.756002117905124E-3</c:v>
                </c:pt>
                <c:pt idx="86">
                  <c:v>2.6561008571622034E-3</c:v>
                </c:pt>
                <c:pt idx="87">
                  <c:v>2.5482381956376679E-3</c:v>
                </c:pt>
                <c:pt idx="88">
                  <c:v>2.4325115029813892E-3</c:v>
                </c:pt>
                <c:pt idx="89">
                  <c:v>2.3187264756955699E-3</c:v>
                </c:pt>
                <c:pt idx="90">
                  <c:v>2.2121983511365932E-3</c:v>
                </c:pt>
                <c:pt idx="91">
                  <c:v>2.1059566079006842E-3</c:v>
                </c:pt>
                <c:pt idx="92">
                  <c:v>1.9967078607724567E-3</c:v>
                </c:pt>
                <c:pt idx="93">
                  <c:v>1.8969898840762969E-3</c:v>
                </c:pt>
                <c:pt idx="94">
                  <c:v>1.7965502264459753E-3</c:v>
                </c:pt>
                <c:pt idx="95">
                  <c:v>1.7050972147338761E-3</c:v>
                </c:pt>
                <c:pt idx="96">
                  <c:v>1.6229286855160079E-3</c:v>
                </c:pt>
                <c:pt idx="97">
                  <c:v>1.5304962496789801E-3</c:v>
                </c:pt>
                <c:pt idx="98">
                  <c:v>1.4552237827208548E-3</c:v>
                </c:pt>
                <c:pt idx="99">
                  <c:v>1.3831072379430667E-3</c:v>
                </c:pt>
              </c:numCache>
            </c:numRef>
          </c:val>
        </c:ser>
        <c:marker val="1"/>
        <c:axId val="73159040"/>
        <c:axId val="73161728"/>
      </c:lineChart>
      <c:catAx>
        <c:axId val="73159040"/>
        <c:scaling>
          <c:orientation val="minMax"/>
        </c:scaling>
        <c:axPos val="b"/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fil-PH" sz="800"/>
            </a:pPr>
            <a:endParaRPr lang="ja-JP"/>
          </a:p>
        </c:txPr>
        <c:crossAx val="73161728"/>
        <c:crosses val="autoZero"/>
        <c:auto val="1"/>
        <c:lblAlgn val="ctr"/>
        <c:lblOffset val="100"/>
      </c:catAx>
      <c:valAx>
        <c:axId val="73161728"/>
        <c:scaling>
          <c:orientation val="minMax"/>
          <c:max val="6.0000000000000032E-2"/>
        </c:scaling>
        <c:axPos val="l"/>
        <c:majorGridlines/>
        <c:numFmt formatCode="General" sourceLinked="0"/>
        <c:tickLblPos val="nextTo"/>
        <c:spPr>
          <a:noFill/>
          <a:ln>
            <a:solidFill>
              <a:schemeClr val="tx1"/>
            </a:solidFill>
          </a:ln>
        </c:spPr>
        <c:txPr>
          <a:bodyPr/>
          <a:lstStyle/>
          <a:p>
            <a:pPr>
              <a:defRPr lang="fil-PH"/>
            </a:pPr>
            <a:endParaRPr lang="ja-JP"/>
          </a:p>
        </c:txPr>
        <c:crossAx val="73159040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</c:chart>
  <c:spPr>
    <a:ln>
      <a:noFill/>
    </a:ln>
  </c:spPr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ja-JP"/>
    </a:p>
  </c:txPr>
  <c:externalData r:id="rId1"/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3781</cdr:x>
      <cdr:y>0.89253</cdr:y>
    </cdr:from>
    <cdr:to>
      <cdr:x>0.64151</cdr:x>
      <cdr:y>0.9864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2431196" y="2516393"/>
          <a:ext cx="1131153" cy="26490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fil-PH" dirty="0">
              <a:latin typeface="Arial" pitchFamily="34" charset="0"/>
              <a:cs typeface="Arial" pitchFamily="34" charset="0"/>
            </a:rPr>
            <a:t>K</a:t>
          </a:r>
          <a:r>
            <a:rPr lang="fil-PH" sz="1100" dirty="0" smtClean="0">
              <a:latin typeface="Arial" pitchFamily="34" charset="0"/>
              <a:cs typeface="Arial" pitchFamily="34" charset="0"/>
            </a:rPr>
            <a:t>-mer depth</a:t>
          </a:r>
          <a:endParaRPr lang="fil-PH" sz="1100" dirty="0">
            <a:latin typeface="Arial" pitchFamily="34" charset="0"/>
            <a:cs typeface="Arial" pitchFamily="34" charset="0"/>
          </a:endParaRPr>
        </a:p>
      </cdr:txBody>
    </cdr:sp>
  </cdr:relSizeAnchor>
  <cdr:relSizeAnchor xmlns:cdr="http://schemas.openxmlformats.org/drawingml/2006/chartDrawing">
    <cdr:from>
      <cdr:x>0.00698</cdr:x>
      <cdr:y>0.52419</cdr:y>
    </cdr:from>
    <cdr:to>
      <cdr:x>0.05056</cdr:x>
      <cdr:y>0.71875</cdr:y>
    </cdr:to>
    <cdr:sp macro="" textlink="">
      <cdr:nvSpPr>
        <cdr:cNvPr id="3" name="TextBox 1"/>
        <cdr:cNvSpPr txBox="1"/>
      </cdr:nvSpPr>
      <cdr:spPr>
        <a:xfrm xmlns:a="http://schemas.openxmlformats.org/drawingml/2006/main" rot="16200000">
          <a:off x="-114517" y="1631181"/>
          <a:ext cx="548543" cy="24200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fil-PH" sz="1200">
              <a:latin typeface="Arial" pitchFamily="34" charset="0"/>
              <a:cs typeface="Arial" pitchFamily="34" charset="0"/>
            </a:rPr>
            <a:t>Ratio</a:t>
          </a:r>
          <a:r>
            <a:rPr lang="fil-PH" sz="1200" baseline="0">
              <a:latin typeface="Arial" pitchFamily="34" charset="0"/>
              <a:cs typeface="Arial" pitchFamily="34" charset="0"/>
            </a:rPr>
            <a:t> of number of </a:t>
          </a:r>
          <a:r>
            <a:rPr lang="fil-PH" sz="1200">
              <a:latin typeface="Arial" pitchFamily="34" charset="0"/>
              <a:cs typeface="Arial" pitchFamily="34" charset="0"/>
            </a:rPr>
            <a:t>k-mer</a:t>
          </a:r>
        </a:p>
      </cdr:txBody>
    </cdr:sp>
  </cdr:relSizeAnchor>
  <cdr:relSizeAnchor xmlns:cdr="http://schemas.openxmlformats.org/drawingml/2006/chartDrawing">
    <cdr:from>
      <cdr:x>0.43781</cdr:x>
      <cdr:y>0.89253</cdr:y>
    </cdr:from>
    <cdr:to>
      <cdr:x>0.64151</cdr:x>
      <cdr:y>0.98649</cdr:y>
    </cdr:to>
    <cdr:sp macro="" textlink="">
      <cdr:nvSpPr>
        <cdr:cNvPr id="4" name="TextBox 1"/>
        <cdr:cNvSpPr txBox="1"/>
      </cdr:nvSpPr>
      <cdr:spPr>
        <a:xfrm xmlns:a="http://schemas.openxmlformats.org/drawingml/2006/main">
          <a:off x="2431192" y="2516398"/>
          <a:ext cx="1131161" cy="26491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fil-PH" dirty="0">
              <a:latin typeface="Arial" pitchFamily="34" charset="0"/>
              <a:cs typeface="Arial" pitchFamily="34" charset="0"/>
            </a:rPr>
            <a:t>K</a:t>
          </a:r>
          <a:r>
            <a:rPr lang="fil-PH" sz="1100" dirty="0" smtClean="0">
              <a:latin typeface="Arial" pitchFamily="34" charset="0"/>
              <a:cs typeface="Arial" pitchFamily="34" charset="0"/>
            </a:rPr>
            <a:t>-mer depth</a:t>
          </a:r>
          <a:endParaRPr lang="fil-PH" sz="1100" dirty="0">
            <a:latin typeface="Arial" pitchFamily="34" charset="0"/>
            <a:cs typeface="Arial" pitchFamily="34" charset="0"/>
          </a:endParaRPr>
        </a:p>
      </cdr:txBody>
    </cdr:sp>
  </cdr:relSizeAnchor>
  <cdr:relSizeAnchor xmlns:cdr="http://schemas.openxmlformats.org/drawingml/2006/chartDrawing">
    <cdr:from>
      <cdr:x>0.00698</cdr:x>
      <cdr:y>0.52419</cdr:y>
    </cdr:from>
    <cdr:to>
      <cdr:x>0.05056</cdr:x>
      <cdr:y>0.71875</cdr:y>
    </cdr:to>
    <cdr:sp macro="" textlink="">
      <cdr:nvSpPr>
        <cdr:cNvPr id="5" name="TextBox 1"/>
        <cdr:cNvSpPr txBox="1"/>
      </cdr:nvSpPr>
      <cdr:spPr>
        <a:xfrm xmlns:a="http://schemas.openxmlformats.org/drawingml/2006/main" rot="16200000">
          <a:off x="-114517" y="1631181"/>
          <a:ext cx="548543" cy="24200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fil-PH" sz="1200">
              <a:latin typeface="Arial" pitchFamily="34" charset="0"/>
              <a:cs typeface="Arial" pitchFamily="34" charset="0"/>
            </a:rPr>
            <a:t>Ratio</a:t>
          </a:r>
          <a:r>
            <a:rPr lang="fil-PH" sz="1200" baseline="0">
              <a:latin typeface="Arial" pitchFamily="34" charset="0"/>
              <a:cs typeface="Arial" pitchFamily="34" charset="0"/>
            </a:rPr>
            <a:t> of number of </a:t>
          </a:r>
          <a:r>
            <a:rPr lang="fil-PH" sz="1200">
              <a:latin typeface="Arial" pitchFamily="34" charset="0"/>
              <a:cs typeface="Arial" pitchFamily="34" charset="0"/>
            </a:rPr>
            <a:t>k-mer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43781</cdr:x>
      <cdr:y>0.89253</cdr:y>
    </cdr:from>
    <cdr:to>
      <cdr:x>0.64151</cdr:x>
      <cdr:y>0.9864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2431196" y="2516393"/>
          <a:ext cx="1131153" cy="26490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fil-PH" sz="1100" dirty="0">
              <a:latin typeface="Arial" pitchFamily="34" charset="0"/>
              <a:cs typeface="Arial" pitchFamily="34" charset="0"/>
            </a:rPr>
            <a:t>K-mer </a:t>
          </a:r>
          <a:r>
            <a:rPr lang="fil-PH" sz="1100" dirty="0" smtClean="0">
              <a:latin typeface="Arial" pitchFamily="34" charset="0"/>
              <a:cs typeface="Arial" pitchFamily="34" charset="0"/>
            </a:rPr>
            <a:t>depth</a:t>
          </a:r>
          <a:endParaRPr lang="fil-PH" sz="1100" dirty="0">
            <a:latin typeface="Arial" pitchFamily="34" charset="0"/>
            <a:cs typeface="Arial" pitchFamily="34" charset="0"/>
          </a:endParaRPr>
        </a:p>
      </cdr:txBody>
    </cdr:sp>
  </cdr:relSizeAnchor>
  <cdr:relSizeAnchor xmlns:cdr="http://schemas.openxmlformats.org/drawingml/2006/chartDrawing">
    <cdr:from>
      <cdr:x>0.00698</cdr:x>
      <cdr:y>0.52419</cdr:y>
    </cdr:from>
    <cdr:to>
      <cdr:x>0.05056</cdr:x>
      <cdr:y>0.71875</cdr:y>
    </cdr:to>
    <cdr:sp macro="" textlink="">
      <cdr:nvSpPr>
        <cdr:cNvPr id="3" name="TextBox 1"/>
        <cdr:cNvSpPr txBox="1"/>
      </cdr:nvSpPr>
      <cdr:spPr>
        <a:xfrm xmlns:a="http://schemas.openxmlformats.org/drawingml/2006/main" rot="16200000">
          <a:off x="-114517" y="1631181"/>
          <a:ext cx="548543" cy="24200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fil-PH" sz="1200">
              <a:latin typeface="Arial" pitchFamily="34" charset="0"/>
              <a:cs typeface="Arial" pitchFamily="34" charset="0"/>
            </a:rPr>
            <a:t>Ratio</a:t>
          </a:r>
          <a:r>
            <a:rPr lang="fil-PH" sz="1200" baseline="0">
              <a:latin typeface="Arial" pitchFamily="34" charset="0"/>
              <a:cs typeface="Arial" pitchFamily="34" charset="0"/>
            </a:rPr>
            <a:t> of number of </a:t>
          </a:r>
          <a:r>
            <a:rPr lang="fil-PH" sz="1200">
              <a:latin typeface="Arial" pitchFamily="34" charset="0"/>
              <a:cs typeface="Arial" pitchFamily="34" charset="0"/>
            </a:rPr>
            <a:t>k-mer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43781</cdr:x>
      <cdr:y>0.89253</cdr:y>
    </cdr:from>
    <cdr:to>
      <cdr:x>0.64151</cdr:x>
      <cdr:y>0.9864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2431196" y="2516393"/>
          <a:ext cx="1131153" cy="26490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fil-PH" sz="1100" dirty="0">
              <a:latin typeface="Arial" pitchFamily="34" charset="0"/>
              <a:cs typeface="Arial" pitchFamily="34" charset="0"/>
            </a:rPr>
            <a:t>K-mer </a:t>
          </a:r>
          <a:r>
            <a:rPr lang="fil-PH" sz="1100" dirty="0" smtClean="0">
              <a:latin typeface="Arial" pitchFamily="34" charset="0"/>
              <a:cs typeface="Arial" pitchFamily="34" charset="0"/>
            </a:rPr>
            <a:t>depth</a:t>
          </a:r>
          <a:endParaRPr lang="fil-PH" sz="1100" dirty="0">
            <a:latin typeface="Arial" pitchFamily="34" charset="0"/>
            <a:cs typeface="Arial" pitchFamily="34" charset="0"/>
          </a:endParaRPr>
        </a:p>
      </cdr:txBody>
    </cdr:sp>
  </cdr:relSizeAnchor>
  <cdr:relSizeAnchor xmlns:cdr="http://schemas.openxmlformats.org/drawingml/2006/chartDrawing">
    <cdr:from>
      <cdr:x>0.00698</cdr:x>
      <cdr:y>0.52419</cdr:y>
    </cdr:from>
    <cdr:to>
      <cdr:x>0.05056</cdr:x>
      <cdr:y>0.71875</cdr:y>
    </cdr:to>
    <cdr:sp macro="" textlink="">
      <cdr:nvSpPr>
        <cdr:cNvPr id="3" name="TextBox 1"/>
        <cdr:cNvSpPr txBox="1"/>
      </cdr:nvSpPr>
      <cdr:spPr>
        <a:xfrm xmlns:a="http://schemas.openxmlformats.org/drawingml/2006/main" rot="16200000">
          <a:off x="-114517" y="1631181"/>
          <a:ext cx="548543" cy="24200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fil-PH" sz="1200">
              <a:latin typeface="Arial" pitchFamily="34" charset="0"/>
              <a:cs typeface="Arial" pitchFamily="34" charset="0"/>
            </a:rPr>
            <a:t>Ratio</a:t>
          </a:r>
          <a:r>
            <a:rPr lang="fil-PH" sz="1200" baseline="0">
              <a:latin typeface="Arial" pitchFamily="34" charset="0"/>
              <a:cs typeface="Arial" pitchFamily="34" charset="0"/>
            </a:rPr>
            <a:t> of number of </a:t>
          </a:r>
          <a:r>
            <a:rPr lang="fil-PH" sz="1200">
              <a:latin typeface="Arial" pitchFamily="34" charset="0"/>
              <a:cs typeface="Arial" pitchFamily="34" charset="0"/>
            </a:rPr>
            <a:t>k-mer</a:t>
          </a: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43781</cdr:x>
      <cdr:y>0.89253</cdr:y>
    </cdr:from>
    <cdr:to>
      <cdr:x>0.64151</cdr:x>
      <cdr:y>0.9864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2431196" y="2516393"/>
          <a:ext cx="1131153" cy="26490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fil-PH" sz="1100" dirty="0">
              <a:latin typeface="Arial" pitchFamily="34" charset="0"/>
              <a:cs typeface="Arial" pitchFamily="34" charset="0"/>
            </a:rPr>
            <a:t>K-mer </a:t>
          </a:r>
          <a:r>
            <a:rPr lang="fil-PH" sz="1100" dirty="0" smtClean="0">
              <a:latin typeface="Arial" pitchFamily="34" charset="0"/>
              <a:cs typeface="Arial" pitchFamily="34" charset="0"/>
            </a:rPr>
            <a:t>depth</a:t>
          </a:r>
          <a:endParaRPr lang="fil-PH" sz="1100" dirty="0">
            <a:latin typeface="Arial" pitchFamily="34" charset="0"/>
            <a:cs typeface="Arial" pitchFamily="34" charset="0"/>
          </a:endParaRPr>
        </a:p>
      </cdr:txBody>
    </cdr:sp>
  </cdr:relSizeAnchor>
  <cdr:relSizeAnchor xmlns:cdr="http://schemas.openxmlformats.org/drawingml/2006/chartDrawing">
    <cdr:from>
      <cdr:x>0.00698</cdr:x>
      <cdr:y>0.52419</cdr:y>
    </cdr:from>
    <cdr:to>
      <cdr:x>0.05056</cdr:x>
      <cdr:y>0.71875</cdr:y>
    </cdr:to>
    <cdr:sp macro="" textlink="">
      <cdr:nvSpPr>
        <cdr:cNvPr id="3" name="TextBox 1"/>
        <cdr:cNvSpPr txBox="1"/>
      </cdr:nvSpPr>
      <cdr:spPr>
        <a:xfrm xmlns:a="http://schemas.openxmlformats.org/drawingml/2006/main" rot="16200000">
          <a:off x="-114517" y="1631181"/>
          <a:ext cx="548543" cy="24200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fil-PH" sz="1200">
              <a:latin typeface="Arial" pitchFamily="34" charset="0"/>
              <a:cs typeface="Arial" pitchFamily="34" charset="0"/>
            </a:rPr>
            <a:t>Ratio</a:t>
          </a:r>
          <a:r>
            <a:rPr lang="fil-PH" sz="1200" baseline="0">
              <a:latin typeface="Arial" pitchFamily="34" charset="0"/>
              <a:cs typeface="Arial" pitchFamily="34" charset="0"/>
            </a:rPr>
            <a:t> of number of </a:t>
          </a:r>
          <a:r>
            <a:rPr lang="fil-PH" sz="1200">
              <a:latin typeface="Arial" pitchFamily="34" charset="0"/>
              <a:cs typeface="Arial" pitchFamily="34" charset="0"/>
            </a:rPr>
            <a:t>k-mer</a:t>
          </a:r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43781</cdr:x>
      <cdr:y>0.89253</cdr:y>
    </cdr:from>
    <cdr:to>
      <cdr:x>0.64151</cdr:x>
      <cdr:y>0.9864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2431196" y="2516393"/>
          <a:ext cx="1131153" cy="26490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fil-PH" sz="1100" dirty="0">
              <a:latin typeface="Arial" pitchFamily="34" charset="0"/>
              <a:cs typeface="Arial" pitchFamily="34" charset="0"/>
            </a:rPr>
            <a:t>K-mer </a:t>
          </a:r>
          <a:r>
            <a:rPr lang="fil-PH" sz="1100" dirty="0" smtClean="0">
              <a:latin typeface="Arial" pitchFamily="34" charset="0"/>
              <a:cs typeface="Arial" pitchFamily="34" charset="0"/>
            </a:rPr>
            <a:t>depth</a:t>
          </a:r>
          <a:endParaRPr lang="fil-PH" sz="1100" dirty="0">
            <a:latin typeface="Arial" pitchFamily="34" charset="0"/>
            <a:cs typeface="Arial" pitchFamily="34" charset="0"/>
          </a:endParaRPr>
        </a:p>
      </cdr:txBody>
    </cdr:sp>
  </cdr:relSizeAnchor>
  <cdr:relSizeAnchor xmlns:cdr="http://schemas.openxmlformats.org/drawingml/2006/chartDrawing">
    <cdr:from>
      <cdr:x>0.00698</cdr:x>
      <cdr:y>0.52419</cdr:y>
    </cdr:from>
    <cdr:to>
      <cdr:x>0.05056</cdr:x>
      <cdr:y>0.71875</cdr:y>
    </cdr:to>
    <cdr:sp macro="" textlink="">
      <cdr:nvSpPr>
        <cdr:cNvPr id="3" name="TextBox 1"/>
        <cdr:cNvSpPr txBox="1"/>
      </cdr:nvSpPr>
      <cdr:spPr>
        <a:xfrm xmlns:a="http://schemas.openxmlformats.org/drawingml/2006/main" rot="16200000">
          <a:off x="-114517" y="1631181"/>
          <a:ext cx="548543" cy="24200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fil-PH" sz="1200">
              <a:latin typeface="Arial" pitchFamily="34" charset="0"/>
              <a:cs typeface="Arial" pitchFamily="34" charset="0"/>
            </a:rPr>
            <a:t>Ratio</a:t>
          </a:r>
          <a:r>
            <a:rPr lang="fil-PH" sz="1200" baseline="0">
              <a:latin typeface="Arial" pitchFamily="34" charset="0"/>
              <a:cs typeface="Arial" pitchFamily="34" charset="0"/>
            </a:rPr>
            <a:t> of number of </a:t>
          </a:r>
          <a:r>
            <a:rPr lang="fil-PH" sz="1200">
              <a:latin typeface="Arial" pitchFamily="34" charset="0"/>
              <a:cs typeface="Arial" pitchFamily="34" charset="0"/>
            </a:rPr>
            <a:t>k-mer</a:t>
          </a:r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43781</cdr:x>
      <cdr:y>0.89253</cdr:y>
    </cdr:from>
    <cdr:to>
      <cdr:x>0.64151</cdr:x>
      <cdr:y>0.9864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2431196" y="2516393"/>
          <a:ext cx="1131153" cy="26490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fil-PH" sz="1100" dirty="0">
              <a:latin typeface="Arial" pitchFamily="34" charset="0"/>
              <a:cs typeface="Arial" pitchFamily="34" charset="0"/>
            </a:rPr>
            <a:t>K-mer </a:t>
          </a:r>
          <a:r>
            <a:rPr lang="fil-PH" sz="1100" dirty="0" smtClean="0">
              <a:latin typeface="Arial" pitchFamily="34" charset="0"/>
              <a:cs typeface="Arial" pitchFamily="34" charset="0"/>
            </a:rPr>
            <a:t>depth</a:t>
          </a:r>
          <a:endParaRPr lang="fil-PH" sz="1100" dirty="0">
            <a:latin typeface="Arial" pitchFamily="34" charset="0"/>
            <a:cs typeface="Arial" pitchFamily="34" charset="0"/>
          </a:endParaRPr>
        </a:p>
      </cdr:txBody>
    </cdr:sp>
  </cdr:relSizeAnchor>
  <cdr:relSizeAnchor xmlns:cdr="http://schemas.openxmlformats.org/drawingml/2006/chartDrawing">
    <cdr:from>
      <cdr:x>0.00698</cdr:x>
      <cdr:y>0.52419</cdr:y>
    </cdr:from>
    <cdr:to>
      <cdr:x>0.05056</cdr:x>
      <cdr:y>0.71875</cdr:y>
    </cdr:to>
    <cdr:sp macro="" textlink="">
      <cdr:nvSpPr>
        <cdr:cNvPr id="3" name="TextBox 1"/>
        <cdr:cNvSpPr txBox="1"/>
      </cdr:nvSpPr>
      <cdr:spPr>
        <a:xfrm xmlns:a="http://schemas.openxmlformats.org/drawingml/2006/main" rot="16200000">
          <a:off x="-114517" y="1631181"/>
          <a:ext cx="548543" cy="24200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fil-PH" sz="1200">
              <a:latin typeface="Arial" pitchFamily="34" charset="0"/>
              <a:cs typeface="Arial" pitchFamily="34" charset="0"/>
            </a:rPr>
            <a:t>Ratio</a:t>
          </a:r>
          <a:r>
            <a:rPr lang="fil-PH" sz="1200" baseline="0">
              <a:latin typeface="Arial" pitchFamily="34" charset="0"/>
              <a:cs typeface="Arial" pitchFamily="34" charset="0"/>
            </a:rPr>
            <a:t> of number of </a:t>
          </a:r>
          <a:r>
            <a:rPr lang="fil-PH" sz="1200">
              <a:latin typeface="Arial" pitchFamily="34" charset="0"/>
              <a:cs typeface="Arial" pitchFamily="34" charset="0"/>
            </a:rPr>
            <a:t>k-mer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27EB1A4-44EC-445D-9E6C-543CCDA64159}" type="datetimeFigureOut">
              <a:rPr kumimoji="1" lang="ja-JP" altLang="en-US" smtClean="0"/>
              <a:pPr/>
              <a:t>2017/11/4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83C8849-FFFB-4B64-9CF7-C230B98416BE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7811518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3D882-9E79-40B2-9249-D8C731099E6D}" type="datetimeFigureOut">
              <a:rPr kumimoji="1" lang="ja-JP" altLang="en-US" smtClean="0"/>
              <a:pPr/>
              <a:t>2017/11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A2F0D-FD98-4601-9B22-3B8C967139C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3D882-9E79-40B2-9249-D8C731099E6D}" type="datetimeFigureOut">
              <a:rPr kumimoji="1" lang="ja-JP" altLang="en-US" smtClean="0"/>
              <a:pPr/>
              <a:t>2017/11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A2F0D-FD98-4601-9B22-3B8C967139C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3D882-9E79-40B2-9249-D8C731099E6D}" type="datetimeFigureOut">
              <a:rPr kumimoji="1" lang="ja-JP" altLang="en-US" smtClean="0"/>
              <a:pPr/>
              <a:t>2017/11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A2F0D-FD98-4601-9B22-3B8C967139C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3D882-9E79-40B2-9249-D8C731099E6D}" type="datetimeFigureOut">
              <a:rPr kumimoji="1" lang="ja-JP" altLang="en-US" smtClean="0"/>
              <a:pPr/>
              <a:t>2017/11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A2F0D-FD98-4601-9B22-3B8C967139C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3D882-9E79-40B2-9249-D8C731099E6D}" type="datetimeFigureOut">
              <a:rPr kumimoji="1" lang="ja-JP" altLang="en-US" smtClean="0"/>
              <a:pPr/>
              <a:t>2017/11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A2F0D-FD98-4601-9B22-3B8C967139C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3D882-9E79-40B2-9249-D8C731099E6D}" type="datetimeFigureOut">
              <a:rPr kumimoji="1" lang="ja-JP" altLang="en-US" smtClean="0"/>
              <a:pPr/>
              <a:t>2017/11/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A2F0D-FD98-4601-9B22-3B8C967139C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3D882-9E79-40B2-9249-D8C731099E6D}" type="datetimeFigureOut">
              <a:rPr kumimoji="1" lang="ja-JP" altLang="en-US" smtClean="0"/>
              <a:pPr/>
              <a:t>2017/11/4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A2F0D-FD98-4601-9B22-3B8C967139C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3D882-9E79-40B2-9249-D8C731099E6D}" type="datetimeFigureOut">
              <a:rPr kumimoji="1" lang="ja-JP" altLang="en-US" smtClean="0"/>
              <a:pPr/>
              <a:t>2017/11/4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A2F0D-FD98-4601-9B22-3B8C967139C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3D882-9E79-40B2-9249-D8C731099E6D}" type="datetimeFigureOut">
              <a:rPr kumimoji="1" lang="ja-JP" altLang="en-US" smtClean="0"/>
              <a:pPr/>
              <a:t>2017/11/4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A2F0D-FD98-4601-9B22-3B8C967139C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3D882-9E79-40B2-9249-D8C731099E6D}" type="datetimeFigureOut">
              <a:rPr kumimoji="1" lang="ja-JP" altLang="en-US" smtClean="0"/>
              <a:pPr/>
              <a:t>2017/11/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A2F0D-FD98-4601-9B22-3B8C967139C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23D882-9E79-40B2-9249-D8C731099E6D}" type="datetimeFigureOut">
              <a:rPr kumimoji="1" lang="ja-JP" altLang="en-US" smtClean="0"/>
              <a:pPr/>
              <a:t>2017/11/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A2F0D-FD98-4601-9B22-3B8C967139C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23D882-9E79-40B2-9249-D8C731099E6D}" type="datetimeFigureOut">
              <a:rPr kumimoji="1" lang="ja-JP" altLang="en-US" smtClean="0"/>
              <a:pPr/>
              <a:t>2017/11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2A2F0D-FD98-4601-9B22-3B8C967139C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テキスト ボックス 39"/>
          <p:cNvSpPr txBox="1"/>
          <p:nvPr/>
        </p:nvSpPr>
        <p:spPr>
          <a:xfrm>
            <a:off x="5505810" y="8196702"/>
            <a:ext cx="9235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Times New Roman" pitchFamily="18" charset="0"/>
                <a:cs typeface="Times New Roman" pitchFamily="18" charset="0"/>
              </a:rPr>
              <a:t>Figure S</a:t>
            </a:r>
            <a:r>
              <a:rPr lang="en-US" altLang="ja-JP" sz="1400" b="1" dirty="0" smtClean="0">
                <a:latin typeface="Times New Roman" pitchFamily="18" charset="0"/>
                <a:cs typeface="Times New Roman" pitchFamily="18" charset="0"/>
              </a:rPr>
              <a:t>1</a:t>
            </a:r>
            <a:endParaRPr kumimoji="1" lang="ja-JP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51" name="Chart 2"/>
          <p:cNvGraphicFramePr/>
          <p:nvPr/>
        </p:nvGraphicFramePr>
        <p:xfrm>
          <a:off x="642918" y="124208"/>
          <a:ext cx="5553075" cy="28193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2" name="Chart 2"/>
          <p:cNvGraphicFramePr/>
          <p:nvPr/>
        </p:nvGraphicFramePr>
        <p:xfrm>
          <a:off x="642918" y="2874571"/>
          <a:ext cx="5553075" cy="28193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3" name="Chart 2"/>
          <p:cNvGraphicFramePr/>
          <p:nvPr/>
        </p:nvGraphicFramePr>
        <p:xfrm>
          <a:off x="660124" y="5677736"/>
          <a:ext cx="5535869" cy="27800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6" name="TextBox 1"/>
          <p:cNvSpPr txBox="1"/>
          <p:nvPr/>
        </p:nvSpPr>
        <p:spPr>
          <a:xfrm>
            <a:off x="525090" y="-3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/>
                <a:cs typeface="Times New Roman"/>
              </a:rPr>
              <a:t>A</a:t>
            </a:r>
            <a:endParaRPr lang="en-US" sz="1600" dirty="0">
              <a:latin typeface="Times New Roman"/>
              <a:cs typeface="Times New Roman"/>
            </a:endParaRPr>
          </a:p>
        </p:txBody>
      </p:sp>
      <p:sp>
        <p:nvSpPr>
          <p:cNvPr id="57" name="TextBox 1"/>
          <p:cNvSpPr txBox="1"/>
          <p:nvPr/>
        </p:nvSpPr>
        <p:spPr>
          <a:xfrm>
            <a:off x="525090" y="276741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/>
                <a:cs typeface="Times New Roman"/>
              </a:rPr>
              <a:t>B</a:t>
            </a:r>
            <a:endParaRPr lang="en-US" sz="1600" dirty="0">
              <a:latin typeface="Times New Roman"/>
              <a:cs typeface="Times New Roman"/>
            </a:endParaRPr>
          </a:p>
        </p:txBody>
      </p:sp>
      <p:sp>
        <p:nvSpPr>
          <p:cNvPr id="60" name="TextBox 1"/>
          <p:cNvSpPr txBox="1"/>
          <p:nvPr/>
        </p:nvSpPr>
        <p:spPr>
          <a:xfrm>
            <a:off x="525090" y="555349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/>
                <a:cs typeface="Times New Roman"/>
              </a:rPr>
              <a:t>C</a:t>
            </a:r>
            <a:endParaRPr lang="en-US" sz="1600" dirty="0">
              <a:latin typeface="Times New Roman"/>
              <a:cs typeface="Times New Roman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0" y="8429652"/>
            <a:ext cx="6989414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igure S1. </a:t>
            </a:r>
            <a:r>
              <a:rPr lang="en-US" sz="1000" b="1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</a:t>
            </a:r>
            <a:r>
              <a:rPr lang="en-US" sz="10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-</a:t>
            </a:r>
            <a:r>
              <a:rPr lang="en-US" sz="1000" b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mer</a:t>
            </a:r>
            <a:r>
              <a:rPr lang="en-US" sz="10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analysis (</a:t>
            </a:r>
            <a:r>
              <a:rPr lang="en-US" sz="1000" b="1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</a:t>
            </a:r>
            <a:r>
              <a:rPr lang="en-US" sz="10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-</a:t>
            </a:r>
            <a:r>
              <a:rPr lang="en-US" sz="1000" b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merlength</a:t>
            </a:r>
            <a:r>
              <a:rPr lang="en-US" sz="10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= 17). </a:t>
            </a:r>
            <a:r>
              <a:rPr 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The X-axis shows k-</a:t>
            </a:r>
            <a:r>
              <a:rPr lang="en-US" sz="10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mer</a:t>
            </a:r>
            <a:r>
              <a:rPr 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depth, and the Y-axis shows proportion that </a:t>
            </a:r>
            <a:endParaRPr lang="en-US" sz="1000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r>
              <a:rPr 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represents </a:t>
            </a:r>
            <a:r>
              <a:rPr 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the frequency at that </a:t>
            </a:r>
            <a:r>
              <a:rPr lang="en-US" sz="1000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</a:t>
            </a:r>
            <a:r>
              <a:rPr 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-</a:t>
            </a:r>
            <a:r>
              <a:rPr lang="en-US" sz="10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mer</a:t>
            </a:r>
            <a:r>
              <a:rPr 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depth divided by to total frequency of all </a:t>
            </a:r>
            <a:r>
              <a:rPr lang="en-US" sz="1000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</a:t>
            </a:r>
            <a:r>
              <a:rPr 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-</a:t>
            </a:r>
            <a:r>
              <a:rPr lang="en-US" sz="10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mer</a:t>
            </a:r>
            <a:r>
              <a:rPr 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depth. (A) WAB56-104, (B) CG14, </a:t>
            </a:r>
            <a:endParaRPr lang="en-US" sz="1000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r>
              <a:rPr 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(</a:t>
            </a:r>
            <a:r>
              <a:rPr 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) NERICA 3, (D) NERICA 4, (E) NERICA 5, (F) NERICA 7. Arrow indicates a peak of heterogeneous </a:t>
            </a:r>
            <a:r>
              <a:rPr lang="en-US" sz="10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sequences.Peak</a:t>
            </a:r>
            <a:r>
              <a:rPr 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</a:t>
            </a:r>
            <a:endParaRPr lang="en-US" sz="1000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r>
              <a:rPr 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between </a:t>
            </a:r>
            <a:r>
              <a:rPr 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0 to 8 of </a:t>
            </a:r>
            <a:r>
              <a:rPr lang="en-US" sz="1000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</a:t>
            </a:r>
            <a:r>
              <a:rPr 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-</a:t>
            </a:r>
            <a:r>
              <a:rPr lang="en-US" sz="10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mer</a:t>
            </a:r>
            <a:r>
              <a:rPr 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depth would be due to sequencing error or contaminants.</a:t>
            </a:r>
            <a:endParaRPr lang="ja-JP" altLang="en-US" sz="1000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endParaRPr kumimoji="1" lang="ja-JP" altLang="en-US" sz="10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0010296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5791562" y="8215338"/>
            <a:ext cx="9235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Times New Roman" pitchFamily="18" charset="0"/>
                <a:cs typeface="Times New Roman" pitchFamily="18" charset="0"/>
              </a:rPr>
              <a:t>Figure S</a:t>
            </a:r>
            <a:r>
              <a:rPr lang="en-US" altLang="ja-JP" sz="1400" b="1" dirty="0" smtClean="0">
                <a:latin typeface="Times New Roman" pitchFamily="18" charset="0"/>
                <a:cs typeface="Times New Roman" pitchFamily="18" charset="0"/>
              </a:rPr>
              <a:t>1</a:t>
            </a:r>
            <a:endParaRPr kumimoji="1" lang="ja-JP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5" name="Chart 2"/>
          <p:cNvGraphicFramePr/>
          <p:nvPr/>
        </p:nvGraphicFramePr>
        <p:xfrm>
          <a:off x="642918" y="142844"/>
          <a:ext cx="5599004" cy="27901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2"/>
          <p:cNvGraphicFramePr/>
          <p:nvPr/>
        </p:nvGraphicFramePr>
        <p:xfrm>
          <a:off x="642918" y="2857488"/>
          <a:ext cx="5599004" cy="27901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Chart 2"/>
          <p:cNvGraphicFramePr/>
          <p:nvPr/>
        </p:nvGraphicFramePr>
        <p:xfrm>
          <a:off x="642918" y="5624934"/>
          <a:ext cx="5599004" cy="27901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8" name="TextBox 1"/>
          <p:cNvSpPr txBox="1"/>
          <p:nvPr/>
        </p:nvSpPr>
        <p:spPr>
          <a:xfrm>
            <a:off x="525090" y="9004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/>
                <a:cs typeface="Times New Roman"/>
              </a:rPr>
              <a:t>D</a:t>
            </a:r>
            <a:endParaRPr lang="en-US" sz="1600" dirty="0">
              <a:latin typeface="Times New Roman"/>
              <a:cs typeface="Times New Roman"/>
            </a:endParaRPr>
          </a:p>
        </p:txBody>
      </p:sp>
      <p:sp>
        <p:nvSpPr>
          <p:cNvPr id="9" name="TextBox 1"/>
          <p:cNvSpPr txBox="1"/>
          <p:nvPr/>
        </p:nvSpPr>
        <p:spPr>
          <a:xfrm>
            <a:off x="525090" y="2786050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/>
                <a:cs typeface="Times New Roman"/>
              </a:rPr>
              <a:t>E</a:t>
            </a:r>
            <a:endParaRPr lang="en-US" sz="1600" dirty="0">
              <a:latin typeface="Times New Roman"/>
              <a:cs typeface="Times New Roman"/>
            </a:endParaRPr>
          </a:p>
        </p:txBody>
      </p:sp>
      <p:sp>
        <p:nvSpPr>
          <p:cNvPr id="10" name="TextBox 1"/>
          <p:cNvSpPr txBox="1"/>
          <p:nvPr/>
        </p:nvSpPr>
        <p:spPr>
          <a:xfrm>
            <a:off x="525090" y="5500694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/>
                <a:cs typeface="Times New Roman"/>
              </a:rPr>
              <a:t>F</a:t>
            </a:r>
            <a:endParaRPr lang="en-US" sz="1600" dirty="0">
              <a:latin typeface="Times New Roman"/>
              <a:cs typeface="Times New Roman"/>
            </a:endParaRPr>
          </a:p>
        </p:txBody>
      </p:sp>
      <p:cxnSp>
        <p:nvCxnSpPr>
          <p:cNvPr id="12" name="直線矢印コネクタ 11"/>
          <p:cNvCxnSpPr/>
          <p:nvPr/>
        </p:nvCxnSpPr>
        <p:spPr>
          <a:xfrm rot="5400000">
            <a:off x="1965315" y="4464049"/>
            <a:ext cx="357190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矢印コネクタ 12"/>
          <p:cNvCxnSpPr/>
          <p:nvPr/>
        </p:nvCxnSpPr>
        <p:spPr>
          <a:xfrm rot="5400000">
            <a:off x="1965315" y="7017181"/>
            <a:ext cx="357190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0"/>
          <p:cNvSpPr txBox="1"/>
          <p:nvPr/>
        </p:nvSpPr>
        <p:spPr>
          <a:xfrm>
            <a:off x="0" y="8429652"/>
            <a:ext cx="6989414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igure S1. </a:t>
            </a:r>
            <a:r>
              <a:rPr lang="en-US" sz="1000" b="1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</a:t>
            </a:r>
            <a:r>
              <a:rPr lang="en-US" sz="10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-</a:t>
            </a:r>
            <a:r>
              <a:rPr lang="en-US" sz="1000" b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mer</a:t>
            </a:r>
            <a:r>
              <a:rPr lang="en-US" sz="10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analysis (</a:t>
            </a:r>
            <a:r>
              <a:rPr lang="en-US" sz="1000" b="1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</a:t>
            </a:r>
            <a:r>
              <a:rPr lang="en-US" sz="10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-</a:t>
            </a:r>
            <a:r>
              <a:rPr lang="en-US" sz="1000" b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merlength</a:t>
            </a:r>
            <a:r>
              <a:rPr lang="en-US" sz="10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= 17). </a:t>
            </a:r>
            <a:r>
              <a:rPr 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The X-axis shows k-</a:t>
            </a:r>
            <a:r>
              <a:rPr lang="en-US" sz="10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mer</a:t>
            </a:r>
            <a:r>
              <a:rPr 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depth, and the Y-axis shows proportion that </a:t>
            </a:r>
            <a:endParaRPr lang="en-US" sz="1000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r>
              <a:rPr 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represents </a:t>
            </a:r>
            <a:r>
              <a:rPr 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the frequency at that </a:t>
            </a:r>
            <a:r>
              <a:rPr lang="en-US" sz="1000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</a:t>
            </a:r>
            <a:r>
              <a:rPr 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-</a:t>
            </a:r>
            <a:r>
              <a:rPr lang="en-US" sz="10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mer</a:t>
            </a:r>
            <a:r>
              <a:rPr 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depth divided by to total frequency of all </a:t>
            </a:r>
            <a:r>
              <a:rPr lang="en-US" sz="1000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</a:t>
            </a:r>
            <a:r>
              <a:rPr 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-</a:t>
            </a:r>
            <a:r>
              <a:rPr lang="en-US" sz="10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mer</a:t>
            </a:r>
            <a:r>
              <a:rPr 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depth. (A) WAB56-104, (B) CG14, </a:t>
            </a:r>
            <a:endParaRPr lang="en-US" sz="1000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r>
              <a:rPr 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(</a:t>
            </a:r>
            <a:r>
              <a:rPr 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) NERICA 3, (D) NERICA 4, (E) NERICA 5, (F) NERICA 7. Arrow indicates a peak of heterogeneous </a:t>
            </a:r>
            <a:r>
              <a:rPr lang="en-US" sz="10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sequences.Peak</a:t>
            </a:r>
            <a:r>
              <a:rPr 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</a:t>
            </a:r>
            <a:endParaRPr lang="en-US" sz="1000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r>
              <a:rPr 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between </a:t>
            </a:r>
            <a:r>
              <a:rPr 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0 to 8 of </a:t>
            </a:r>
            <a:r>
              <a:rPr lang="en-US" sz="1000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</a:t>
            </a:r>
            <a:r>
              <a:rPr 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-</a:t>
            </a:r>
            <a:r>
              <a:rPr lang="en-US" sz="10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mer</a:t>
            </a:r>
            <a:r>
              <a:rPr 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depth would be due to sequencing error or contaminants.</a:t>
            </a:r>
            <a:endParaRPr lang="ja-JP" altLang="en-US" sz="1000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endParaRPr kumimoji="1" lang="ja-JP" altLang="en-US" sz="10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193</TotalTime>
  <Words>263</Words>
  <Application>Microsoft Macintosh PowerPoint</Application>
  <PresentationFormat>画面に合わせる (4:3)</PresentationFormat>
  <Paragraphs>36</Paragraphs>
  <Slides>2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Office テーマ</vt:lpstr>
      <vt:lpstr>スライド 1</vt:lpstr>
      <vt:lpstr>スライド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USER</dc:creator>
  <cp:lastModifiedBy>naokiy</cp:lastModifiedBy>
  <cp:revision>418</cp:revision>
  <dcterms:created xsi:type="dcterms:W3CDTF">2014-08-02T13:00:02Z</dcterms:created>
  <dcterms:modified xsi:type="dcterms:W3CDTF">2017-11-04T05:14:44Z</dcterms:modified>
</cp:coreProperties>
</file>